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6" r:id="rId2"/>
    <p:sldId id="276" r:id="rId3"/>
    <p:sldId id="292" r:id="rId4"/>
    <p:sldId id="312" r:id="rId5"/>
    <p:sldId id="344" r:id="rId6"/>
    <p:sldId id="342" r:id="rId7"/>
    <p:sldId id="348" r:id="rId8"/>
    <p:sldId id="349" r:id="rId9"/>
    <p:sldId id="302" r:id="rId10"/>
    <p:sldId id="303" r:id="rId11"/>
    <p:sldId id="321" r:id="rId12"/>
    <p:sldId id="322" r:id="rId13"/>
    <p:sldId id="323" r:id="rId14"/>
    <p:sldId id="350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99"/>
    <a:srgbClr val="9FE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1D1092-A763-427C-AEE0-95D2C75160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32B581-24A4-4EE1-A1A1-CA051E8D31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4B5C42-BF62-4AA1-ABB5-1726EE12F7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0BB98E-4EEC-4F96-BCE7-37371D82D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504C00-7FF4-4DFF-8880-960C0E51C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94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CA47B2-FA9C-4420-9B3A-4C56F68304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0E7932-307B-4BCB-A145-5829484E72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D5A1A6-EE1C-4A6A-A2DD-F4F0A2A45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1434F3-9A75-4B9C-B2F1-499063F92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BCAC7C-1F71-4038-B114-5D7832740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713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F1DF36C-ECC3-4244-9791-BB02852B54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90FC33-D8E9-4962-8257-31F177A0E7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1BC0DB-5FC4-431B-91B9-BAD0D19C7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AD4D5-A45D-481E-9721-DC37DC35E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00CA70-9290-4474-B9C1-E0B33CF55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967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C29985-4324-4495-93C2-5E00AF3531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FFDB51-3F48-46B8-A75E-9E6C1D5D6D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C03312-ECF3-44B4-88D1-52E4D1B01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6433EE-68FD-47E2-B5E3-ECC5CA3E4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7E9827-93EC-4D45-B33E-EC1C5F4E0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876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3107CD-3F06-4A48-9722-542253ED4C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F3695D-FA66-488D-98BB-88DDC4DC6E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0C2A13-1CE3-4931-B5DE-B0193209A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478BE5-851F-4FB2-B44F-C5260661A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5B5ED6-DAFE-4FA9-9B9C-3738467B73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38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A0FA1-88B5-409E-A945-1FD36E152B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31191F-BF49-4098-B2FE-C0C78E4B9B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BC56DE-1DE5-47B2-9776-E35D45EA72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F71EEA-09EE-4501-BEA4-FC93849E53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A7C280-DD2C-4D63-B35C-E98F69D11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04A974-7BB3-468A-9424-9609E19D3C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721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D4E3BA-3185-4A00-ACB5-BF2FEBDC2F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772ABB-AE65-4B4C-BFEA-CE1AA15D41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CA82D3-A999-4E08-8DAE-79A0D4C1C1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C16D544-4A60-46E7-8EBC-7395B07A4D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356132-F318-410A-91D7-C44E76A721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91F00F6-E188-4285-91F9-0849895250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EAC685-4869-41CA-8D4A-99FFA96E0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E216A92-098A-4B9D-9808-701792ABD5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95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F3C344-DDF9-47AF-82CD-8B7446A3FB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E193060-225D-4DC9-A74E-987FAD062D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B4B1628-22D0-40C9-B213-7E8726990A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4EDC96-78D5-4381-A0B2-7E077D64B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64825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69F940E-CC3B-4CAE-8B03-9E84659E9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ECFBB98-8F8F-4249-9329-15BD5A3C3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E32915-DC36-4CCB-9EA7-D1027AF40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610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2C1C9-55FC-4D9D-BB78-779DACF9E7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94560F-BDD5-4CEE-A3D7-9D1625B951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1C8B26-8E70-4021-B867-94D1FD6B08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A28629-30C9-4D1A-9A83-74566F9FA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8CF291-4266-4A0A-870A-9EC99AA17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336681-20DA-44B4-8A96-9F314DAF4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368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D582C2-5638-4767-8EA4-70FFB7581D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16DB649-259D-4EF7-A908-4FC995F587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C24A15-E803-4FCA-9C48-994FDAA45C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912A2A-03DD-4FE5-B5E4-0EE3C6BE07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B9D0DC-9248-4D48-9505-A00224716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980FD5-E3D7-49E8-887F-6E92CCAE3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585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4B9E20A-627D-450C-B207-5CE45615C7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2628F6-236D-4156-AC36-B45B8C9FBE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909A9A-6956-480E-A68C-92F2BB1A47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E3E90-CBD4-4EB7-BD95-0DBAA456C5AD}" type="datetimeFigureOut">
              <a:rPr lang="en-US" smtClean="0"/>
              <a:t>5/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0253D4-2E8C-40E3-AAB4-159E59B94D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FD7F4D-B266-4AE2-873F-8873DC291B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8C0B0E-5387-4F75-8B60-25A1630F66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370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png"/><Relationship Id="rId3" Type="http://schemas.openxmlformats.org/officeDocument/2006/relationships/image" Target="../media/image55.png"/><Relationship Id="rId7" Type="http://schemas.openxmlformats.org/officeDocument/2006/relationships/image" Target="../media/image59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8.png"/><Relationship Id="rId5" Type="http://schemas.openxmlformats.org/officeDocument/2006/relationships/image" Target="../media/image57.png"/><Relationship Id="rId4" Type="http://schemas.openxmlformats.org/officeDocument/2006/relationships/image" Target="../media/image56.png"/><Relationship Id="rId9" Type="http://schemas.openxmlformats.org/officeDocument/2006/relationships/image" Target="../media/image61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png"/><Relationship Id="rId3" Type="http://schemas.openxmlformats.org/officeDocument/2006/relationships/image" Target="../media/image63.png"/><Relationship Id="rId7" Type="http://schemas.openxmlformats.org/officeDocument/2006/relationships/image" Target="../media/image67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png"/><Relationship Id="rId5" Type="http://schemas.openxmlformats.org/officeDocument/2006/relationships/image" Target="../media/image65.png"/><Relationship Id="rId4" Type="http://schemas.openxmlformats.org/officeDocument/2006/relationships/image" Target="../media/image64.png"/><Relationship Id="rId9" Type="http://schemas.openxmlformats.org/officeDocument/2006/relationships/image" Target="../media/image69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png"/><Relationship Id="rId3" Type="http://schemas.openxmlformats.org/officeDocument/2006/relationships/image" Target="../media/image71.png"/><Relationship Id="rId7" Type="http://schemas.openxmlformats.org/officeDocument/2006/relationships/image" Target="../media/image75.png"/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4.png"/><Relationship Id="rId5" Type="http://schemas.openxmlformats.org/officeDocument/2006/relationships/image" Target="../media/image73.png"/><Relationship Id="rId4" Type="http://schemas.openxmlformats.org/officeDocument/2006/relationships/image" Target="../media/image72.png"/><Relationship Id="rId9" Type="http://schemas.openxmlformats.org/officeDocument/2006/relationships/image" Target="../media/image77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png"/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1.png"/><Relationship Id="rId4" Type="http://schemas.openxmlformats.org/officeDocument/2006/relationships/image" Target="../media/image80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8.png"/><Relationship Id="rId13" Type="http://schemas.openxmlformats.org/officeDocument/2006/relationships/image" Target="../media/image93.png"/><Relationship Id="rId3" Type="http://schemas.openxmlformats.org/officeDocument/2006/relationships/image" Target="../media/image83.png"/><Relationship Id="rId7" Type="http://schemas.openxmlformats.org/officeDocument/2006/relationships/image" Target="../media/image87.png"/><Relationship Id="rId12" Type="http://schemas.openxmlformats.org/officeDocument/2006/relationships/image" Target="../media/image92.png"/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6.png"/><Relationship Id="rId11" Type="http://schemas.openxmlformats.org/officeDocument/2006/relationships/image" Target="../media/image91.png"/><Relationship Id="rId5" Type="http://schemas.openxmlformats.org/officeDocument/2006/relationships/image" Target="../media/image85.png"/><Relationship Id="rId10" Type="http://schemas.openxmlformats.org/officeDocument/2006/relationships/image" Target="../media/image90.png"/><Relationship Id="rId4" Type="http://schemas.openxmlformats.org/officeDocument/2006/relationships/image" Target="../media/image84.png"/><Relationship Id="rId9" Type="http://schemas.openxmlformats.org/officeDocument/2006/relationships/image" Target="../media/image89.png"/><Relationship Id="rId14" Type="http://schemas.openxmlformats.org/officeDocument/2006/relationships/image" Target="../media/image94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eg"/><Relationship Id="rId3" Type="http://schemas.openxmlformats.org/officeDocument/2006/relationships/image" Target="../media/image12.jpeg"/><Relationship Id="rId7" Type="http://schemas.openxmlformats.org/officeDocument/2006/relationships/image" Target="../media/image16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jpeg"/><Relationship Id="rId9" Type="http://schemas.openxmlformats.org/officeDocument/2006/relationships/image" Target="../media/image18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4" Type="http://schemas.openxmlformats.org/officeDocument/2006/relationships/image" Target="../media/image21.jpeg"/><Relationship Id="rId9" Type="http://schemas.openxmlformats.org/officeDocument/2006/relationships/image" Target="../media/image26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jpeg"/><Relationship Id="rId3" Type="http://schemas.openxmlformats.org/officeDocument/2006/relationships/image" Target="../media/image28.jpeg"/><Relationship Id="rId7" Type="http://schemas.openxmlformats.org/officeDocument/2006/relationships/image" Target="../media/image32.jpeg"/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jpeg"/><Relationship Id="rId5" Type="http://schemas.openxmlformats.org/officeDocument/2006/relationships/image" Target="../media/image30.jpeg"/><Relationship Id="rId4" Type="http://schemas.openxmlformats.org/officeDocument/2006/relationships/image" Target="../media/image29.jpeg"/><Relationship Id="rId9" Type="http://schemas.openxmlformats.org/officeDocument/2006/relationships/image" Target="../media/image34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jpeg"/><Relationship Id="rId3" Type="http://schemas.openxmlformats.org/officeDocument/2006/relationships/image" Target="../media/image36.jpeg"/><Relationship Id="rId7" Type="http://schemas.openxmlformats.org/officeDocument/2006/relationships/image" Target="../media/image40.jpeg"/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5" Type="http://schemas.openxmlformats.org/officeDocument/2006/relationships/image" Target="../media/image38.jpeg"/><Relationship Id="rId4" Type="http://schemas.openxmlformats.org/officeDocument/2006/relationships/image" Target="../media/image37.jpeg"/><Relationship Id="rId9" Type="http://schemas.openxmlformats.org/officeDocument/2006/relationships/image" Target="../media/image42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jpe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5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3" Type="http://schemas.openxmlformats.org/officeDocument/2006/relationships/image" Target="../media/image47.jpeg"/><Relationship Id="rId7" Type="http://schemas.openxmlformats.org/officeDocument/2006/relationships/image" Target="../media/image51.png"/><Relationship Id="rId2" Type="http://schemas.openxmlformats.org/officeDocument/2006/relationships/image" Target="../media/image4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png"/><Relationship Id="rId5" Type="http://schemas.openxmlformats.org/officeDocument/2006/relationships/image" Target="../media/image49.png"/><Relationship Id="rId4" Type="http://schemas.openxmlformats.org/officeDocument/2006/relationships/image" Target="../media/image48.jpeg"/><Relationship Id="rId9" Type="http://schemas.openxmlformats.org/officeDocument/2006/relationships/image" Target="../media/image5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894F497-8394-3B46-304D-D899E44C5276}"/>
              </a:ext>
            </a:extLst>
          </p:cNvPr>
          <p:cNvGrpSpPr/>
          <p:nvPr/>
        </p:nvGrpSpPr>
        <p:grpSpPr>
          <a:xfrm>
            <a:off x="185840" y="431800"/>
            <a:ext cx="10543842" cy="4401332"/>
            <a:chOff x="185840" y="431800"/>
            <a:chExt cx="10543842" cy="4401332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46B04ABD-A82F-4861-AE56-922E7CE212DD}"/>
                </a:ext>
              </a:extLst>
            </p:cNvPr>
            <p:cNvGrpSpPr/>
            <p:nvPr/>
          </p:nvGrpSpPr>
          <p:grpSpPr>
            <a:xfrm>
              <a:off x="185840" y="431800"/>
              <a:ext cx="5243964" cy="4401332"/>
              <a:chOff x="185840" y="431800"/>
              <a:chExt cx="5243964" cy="4401332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3D23FBA3-131C-488C-921B-BA1F828409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82" t="10741" r="8913" b="5062"/>
              <a:stretch/>
            </p:blipFill>
            <p:spPr>
              <a:xfrm>
                <a:off x="185840" y="801132"/>
                <a:ext cx="5243964" cy="4032000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8E480F65-7095-492E-93CC-8842F5253F38}"/>
                  </a:ext>
                </a:extLst>
              </p:cNvPr>
              <p:cNvSpPr txBox="1"/>
              <p:nvPr/>
            </p:nvSpPr>
            <p:spPr>
              <a:xfrm>
                <a:off x="414867" y="431800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A</a:t>
                </a:r>
                <a:endParaRPr lang="en-US" dirty="0"/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8CC91BDF-429F-4940-94DF-6D8C7CA517FD}"/>
                </a:ext>
              </a:extLst>
            </p:cNvPr>
            <p:cNvGrpSpPr/>
            <p:nvPr/>
          </p:nvGrpSpPr>
          <p:grpSpPr>
            <a:xfrm>
              <a:off x="5658831" y="431800"/>
              <a:ext cx="5070851" cy="4382532"/>
              <a:chOff x="5658831" y="431800"/>
              <a:chExt cx="5070851" cy="4382532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1F52228C-B664-4056-80D5-0F2F6E4AFA9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55" t="10370" r="9210" b="5309"/>
              <a:stretch/>
            </p:blipFill>
            <p:spPr>
              <a:xfrm>
                <a:off x="5658831" y="801132"/>
                <a:ext cx="5070851" cy="4013200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27BBACCB-F682-4F88-AFF8-56F80F4C6C7F}"/>
                  </a:ext>
                </a:extLst>
              </p:cNvPr>
              <p:cNvSpPr txBox="1"/>
              <p:nvPr/>
            </p:nvSpPr>
            <p:spPr>
              <a:xfrm>
                <a:off x="6096000" y="431800"/>
                <a:ext cx="30970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B</a:t>
                </a:r>
                <a:endParaRPr lang="en-US" dirty="0"/>
              </a:p>
            </p:txBody>
          </p:sp>
        </p:grpSp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23135219-D9D7-4EE3-86AE-542036455E42}"/>
              </a:ext>
            </a:extLst>
          </p:cNvPr>
          <p:cNvSpPr/>
          <p:nvPr/>
        </p:nvSpPr>
        <p:spPr>
          <a:xfrm>
            <a:off x="1065350" y="5029775"/>
            <a:ext cx="106807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licability Domain Plot. (A) Based o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DKit+PaDEL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D descriptors. (B) Based on ECFPs fingerprints. </a:t>
            </a:r>
          </a:p>
        </p:txBody>
      </p:sp>
    </p:spTree>
    <p:extLst>
      <p:ext uri="{BB962C8B-B14F-4D97-AF65-F5344CB8AC3E}">
        <p14:creationId xmlns:p14="http://schemas.microsoft.com/office/powerpoint/2010/main" val="20907570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4FD0F6A-27EF-4C43-B226-0D3EB3ADD59F}"/>
              </a:ext>
            </a:extLst>
          </p:cNvPr>
          <p:cNvGrpSpPr/>
          <p:nvPr/>
        </p:nvGrpSpPr>
        <p:grpSpPr>
          <a:xfrm>
            <a:off x="17363" y="604756"/>
            <a:ext cx="12112253" cy="5118538"/>
            <a:chOff x="17363" y="604756"/>
            <a:chExt cx="12112253" cy="5118538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EAD3E984-0432-45E1-B9AE-F6CB12379742}"/>
                </a:ext>
              </a:extLst>
            </p:cNvPr>
            <p:cNvGrpSpPr/>
            <p:nvPr/>
          </p:nvGrpSpPr>
          <p:grpSpPr>
            <a:xfrm>
              <a:off x="20140" y="634510"/>
              <a:ext cx="2916000" cy="2463242"/>
              <a:chOff x="0" y="111081"/>
              <a:chExt cx="2916000" cy="2463242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50D771BB-15BC-4C4A-A83D-44F8756286A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3655"/>
              <a:stretch/>
            </p:blipFill>
            <p:spPr>
              <a:xfrm>
                <a:off x="0" y="428106"/>
                <a:ext cx="2916000" cy="2146217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07880B61-B0A1-4602-A178-3CFC0B10141D}"/>
                  </a:ext>
                </a:extLst>
              </p:cNvPr>
              <p:cNvSpPr txBox="1"/>
              <p:nvPr/>
            </p:nvSpPr>
            <p:spPr>
              <a:xfrm>
                <a:off x="1023285" y="111081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8</a:t>
                </a:r>
                <a:endParaRPr lang="en-US" dirty="0"/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97A4C997-CB28-4F2A-A257-917CE83E2C42}"/>
                </a:ext>
              </a:extLst>
            </p:cNvPr>
            <p:cNvGrpSpPr/>
            <p:nvPr/>
          </p:nvGrpSpPr>
          <p:grpSpPr>
            <a:xfrm>
              <a:off x="3180000" y="634510"/>
              <a:ext cx="2916000" cy="2408770"/>
              <a:chOff x="5760000" y="176259"/>
              <a:chExt cx="2916000" cy="2408770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556D8AEB-2A55-4DCE-897B-AF876802FD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3609"/>
              <a:stretch/>
            </p:blipFill>
            <p:spPr>
              <a:xfrm>
                <a:off x="5760000" y="467222"/>
                <a:ext cx="2916000" cy="2117807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3CAC1B37-F627-470C-A696-0CE082C2E247}"/>
                  </a:ext>
                </a:extLst>
              </p:cNvPr>
              <p:cNvSpPr txBox="1"/>
              <p:nvPr/>
            </p:nvSpPr>
            <p:spPr>
              <a:xfrm>
                <a:off x="6690512" y="176259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34</a:t>
                </a:r>
                <a:endParaRPr lang="en-US" dirty="0"/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DA9503A7-09AF-44BA-854B-C6B137687860}"/>
                </a:ext>
              </a:extLst>
            </p:cNvPr>
            <p:cNvGrpSpPr/>
            <p:nvPr/>
          </p:nvGrpSpPr>
          <p:grpSpPr>
            <a:xfrm>
              <a:off x="6167999" y="604756"/>
              <a:ext cx="2916000" cy="2438524"/>
              <a:chOff x="8604000" y="176259"/>
              <a:chExt cx="2916000" cy="2438524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3AD6C89B-72AF-45F1-95E6-F406ADD607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4691"/>
              <a:stretch/>
            </p:blipFill>
            <p:spPr>
              <a:xfrm>
                <a:off x="8604000" y="522426"/>
                <a:ext cx="2916000" cy="2092357"/>
              </a:xfrm>
              <a:prstGeom prst="rect">
                <a:avLst/>
              </a:prstGeom>
            </p:spPr>
          </p:pic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3BBC129-8F85-41DB-A01B-B780C86AFAD6}"/>
                  </a:ext>
                </a:extLst>
              </p:cNvPr>
              <p:cNvSpPr txBox="1"/>
              <p:nvPr/>
            </p:nvSpPr>
            <p:spPr>
              <a:xfrm>
                <a:off x="9662312" y="176259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41</a:t>
                </a:r>
                <a:endParaRPr lang="en-US" dirty="0"/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866E543F-6FF9-4330-830E-0C2BBB57C593}"/>
                </a:ext>
              </a:extLst>
            </p:cNvPr>
            <p:cNvGrpSpPr/>
            <p:nvPr/>
          </p:nvGrpSpPr>
          <p:grpSpPr>
            <a:xfrm>
              <a:off x="9193476" y="604756"/>
              <a:ext cx="2880000" cy="2563754"/>
              <a:chOff x="155236" y="303350"/>
              <a:chExt cx="3024000" cy="2563754"/>
            </a:xfrm>
          </p:grpSpPr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11CA65A2-80A0-4FDA-B438-B2D590BFD37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" t="3008" r="1581"/>
              <a:stretch/>
            </p:blipFill>
            <p:spPr>
              <a:xfrm>
                <a:off x="155236" y="582750"/>
                <a:ext cx="3024000" cy="2284354"/>
              </a:xfrm>
              <a:prstGeom prst="rect">
                <a:avLst/>
              </a:prstGeom>
            </p:spPr>
          </p:pic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D9FC0B49-5B67-48E6-B231-C1965C603112}"/>
                  </a:ext>
                </a:extLst>
              </p:cNvPr>
              <p:cNvSpPr txBox="1"/>
              <p:nvPr/>
            </p:nvSpPr>
            <p:spPr>
              <a:xfrm>
                <a:off x="1143795" y="303350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43</a:t>
                </a:r>
                <a:endParaRPr lang="en-US" dirty="0"/>
              </a:p>
            </p:txBody>
          </p: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9CBC4428-F6E7-4634-B886-2091846A5209}"/>
                </a:ext>
              </a:extLst>
            </p:cNvPr>
            <p:cNvGrpSpPr/>
            <p:nvPr/>
          </p:nvGrpSpPr>
          <p:grpSpPr>
            <a:xfrm>
              <a:off x="17363" y="3229554"/>
              <a:ext cx="2880000" cy="2493740"/>
              <a:chOff x="3284729" y="303350"/>
              <a:chExt cx="3024000" cy="2493740"/>
            </a:xfrm>
          </p:grpSpPr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0DBF07B4-9ED7-44AC-9BA1-06C150B15E8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284729" y="488016"/>
                <a:ext cx="3024000" cy="2309074"/>
              </a:xfrm>
              <a:prstGeom prst="rect">
                <a:avLst/>
              </a:prstGeom>
            </p:spPr>
          </p:pic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8860E6BA-F9ED-4E86-AA61-FD4F45F8ECF8}"/>
                  </a:ext>
                </a:extLst>
              </p:cNvPr>
              <p:cNvSpPr txBox="1"/>
              <p:nvPr/>
            </p:nvSpPr>
            <p:spPr>
              <a:xfrm>
                <a:off x="4361128" y="303350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44</a:t>
                </a:r>
                <a:endParaRPr lang="en-US" dirty="0"/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0FA237DC-56F0-4C8C-B36D-730286823E3E}"/>
                </a:ext>
              </a:extLst>
            </p:cNvPr>
            <p:cNvGrpSpPr/>
            <p:nvPr/>
          </p:nvGrpSpPr>
          <p:grpSpPr>
            <a:xfrm>
              <a:off x="3287999" y="3147810"/>
              <a:ext cx="2880000" cy="2575484"/>
              <a:chOff x="6426199" y="307845"/>
              <a:chExt cx="3024000" cy="2575484"/>
            </a:xfrm>
          </p:grpSpPr>
          <p:pic>
            <p:nvPicPr>
              <p:cNvPr id="41" name="Picture 40">
                <a:extLst>
                  <a:ext uri="{FF2B5EF4-FFF2-40B4-BE49-F238E27FC236}">
                    <a16:creationId xmlns:a16="http://schemas.microsoft.com/office/drawing/2014/main" id="{436D9271-C63F-4A9D-A375-DDCB0E3CDE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4112" t="3935" r="961"/>
              <a:stretch/>
            </p:blipFill>
            <p:spPr>
              <a:xfrm>
                <a:off x="6426199" y="582750"/>
                <a:ext cx="3024000" cy="2300579"/>
              </a:xfrm>
              <a:prstGeom prst="rect">
                <a:avLst/>
              </a:prstGeom>
            </p:spPr>
          </p:pic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D809749C-8C31-4127-ACEE-68EF1E99C276}"/>
                  </a:ext>
                </a:extLst>
              </p:cNvPr>
              <p:cNvSpPr txBox="1"/>
              <p:nvPr/>
            </p:nvSpPr>
            <p:spPr>
              <a:xfrm>
                <a:off x="7527661" y="307845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49</a:t>
                </a:r>
                <a:endParaRPr lang="en-US" dirty="0"/>
              </a:p>
            </p:txBody>
          </p: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EB3B59C6-8D89-49FB-8C26-4DBAD8153FA9}"/>
                </a:ext>
              </a:extLst>
            </p:cNvPr>
            <p:cNvGrpSpPr/>
            <p:nvPr/>
          </p:nvGrpSpPr>
          <p:grpSpPr>
            <a:xfrm>
              <a:off x="6204738" y="3097752"/>
              <a:ext cx="2880000" cy="2600832"/>
              <a:chOff x="9140464" y="269484"/>
              <a:chExt cx="3024000" cy="2600832"/>
            </a:xfrm>
          </p:grpSpPr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AA4CFF52-4C81-475A-9A85-ACB361312D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9140464" y="566526"/>
                <a:ext cx="3024000" cy="2303790"/>
              </a:xfrm>
              <a:prstGeom prst="rect">
                <a:avLst/>
              </a:prstGeom>
            </p:spPr>
          </p:pic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FDFDC426-1A8F-43F3-B31D-EC5560282011}"/>
                  </a:ext>
                </a:extLst>
              </p:cNvPr>
              <p:cNvSpPr txBox="1"/>
              <p:nvPr/>
            </p:nvSpPr>
            <p:spPr>
              <a:xfrm>
                <a:off x="10227624" y="269484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52</a:t>
                </a:r>
                <a:endParaRPr lang="en-US" dirty="0"/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7CFF50B9-9837-430B-B953-7B6C7E054F98}"/>
                </a:ext>
              </a:extLst>
            </p:cNvPr>
            <p:cNvGrpSpPr/>
            <p:nvPr/>
          </p:nvGrpSpPr>
          <p:grpSpPr>
            <a:xfrm>
              <a:off x="9213616" y="3147810"/>
              <a:ext cx="2916000" cy="2519437"/>
              <a:chOff x="108207" y="2891348"/>
              <a:chExt cx="2916000" cy="2519437"/>
            </a:xfrm>
          </p:grpSpPr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F894A9FC-4414-4325-8C53-3315560C3D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t="2210"/>
              <a:stretch/>
            </p:blipFill>
            <p:spPr>
              <a:xfrm>
                <a:off x="108207" y="3156571"/>
                <a:ext cx="2916000" cy="2254214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BFBEB104-C770-4AE3-A781-3382ED1BE9D7}"/>
                  </a:ext>
                </a:extLst>
              </p:cNvPr>
              <p:cNvSpPr txBox="1"/>
              <p:nvPr/>
            </p:nvSpPr>
            <p:spPr>
              <a:xfrm>
                <a:off x="1002719" y="2891348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55</a:t>
                </a:r>
                <a:endParaRPr 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6504654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A84E714-3B94-47E8-B37B-884745861E3B}"/>
              </a:ext>
            </a:extLst>
          </p:cNvPr>
          <p:cNvGrpSpPr/>
          <p:nvPr/>
        </p:nvGrpSpPr>
        <p:grpSpPr>
          <a:xfrm>
            <a:off x="0" y="629664"/>
            <a:ext cx="12056814" cy="5307247"/>
            <a:chOff x="0" y="629664"/>
            <a:chExt cx="12056814" cy="5307247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55804B71-3C87-4CF8-998D-8C5809A4D426}"/>
                </a:ext>
              </a:extLst>
            </p:cNvPr>
            <p:cNvGrpSpPr/>
            <p:nvPr/>
          </p:nvGrpSpPr>
          <p:grpSpPr>
            <a:xfrm>
              <a:off x="6224814" y="677746"/>
              <a:ext cx="2916000" cy="2445953"/>
              <a:chOff x="8731799" y="2905354"/>
              <a:chExt cx="2916000" cy="2445953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AE4E805A-06CD-4FB3-B352-46A327967DA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3855"/>
              <a:stretch/>
            </p:blipFill>
            <p:spPr>
              <a:xfrm>
                <a:off x="8731799" y="3156571"/>
                <a:ext cx="2916000" cy="2194736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5CEEB2CA-0549-43AE-9D0F-EA350F746F1A}"/>
                  </a:ext>
                </a:extLst>
              </p:cNvPr>
              <p:cNvSpPr txBox="1"/>
              <p:nvPr/>
            </p:nvSpPr>
            <p:spPr>
              <a:xfrm>
                <a:off x="9782399" y="2905354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02</a:t>
                </a:r>
                <a:endParaRPr lang="en-US" dirty="0"/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AA8567D7-A3B0-4FEC-9651-61C1B7D297BE}"/>
                </a:ext>
              </a:extLst>
            </p:cNvPr>
            <p:cNvGrpSpPr/>
            <p:nvPr/>
          </p:nvGrpSpPr>
          <p:grpSpPr>
            <a:xfrm>
              <a:off x="0" y="629664"/>
              <a:ext cx="2916000" cy="2422146"/>
              <a:chOff x="2916000" y="2891348"/>
              <a:chExt cx="2916000" cy="2422146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837F7FE6-0142-4910-943B-344F1559A52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4303"/>
              <a:stretch/>
            </p:blipFill>
            <p:spPr>
              <a:xfrm>
                <a:off x="2916000" y="3167277"/>
                <a:ext cx="2916000" cy="2146217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F7EB8F5-E9C8-43BE-AC61-43601FDA676B}"/>
                  </a:ext>
                </a:extLst>
              </p:cNvPr>
              <p:cNvSpPr txBox="1"/>
              <p:nvPr/>
            </p:nvSpPr>
            <p:spPr>
              <a:xfrm>
                <a:off x="3954719" y="2891348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60</a:t>
                </a:r>
                <a:endParaRPr lang="en-US" dirty="0"/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D927FDAF-1D87-428A-9EF6-2CB113A7CD04}"/>
                </a:ext>
              </a:extLst>
            </p:cNvPr>
            <p:cNvGrpSpPr/>
            <p:nvPr/>
          </p:nvGrpSpPr>
          <p:grpSpPr>
            <a:xfrm>
              <a:off x="3204413" y="629664"/>
              <a:ext cx="2916000" cy="2494035"/>
              <a:chOff x="5815799" y="2885379"/>
              <a:chExt cx="2916000" cy="2494035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56232629-7822-4709-B9CC-2C9C486E98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5371"/>
              <a:stretch/>
            </p:blipFill>
            <p:spPr>
              <a:xfrm>
                <a:off x="5815799" y="3156571"/>
                <a:ext cx="2916000" cy="2222843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C2539FA5-85BC-4467-BFF0-A42F56922DAE}"/>
                  </a:ext>
                </a:extLst>
              </p:cNvPr>
              <p:cNvSpPr txBox="1"/>
              <p:nvPr/>
            </p:nvSpPr>
            <p:spPr>
              <a:xfrm>
                <a:off x="6762512" y="2885379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96</a:t>
                </a:r>
                <a:endParaRPr lang="en-US" dirty="0"/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6E1A930F-3540-4CBB-9D93-15FB6BCE723E}"/>
                </a:ext>
              </a:extLst>
            </p:cNvPr>
            <p:cNvGrpSpPr/>
            <p:nvPr/>
          </p:nvGrpSpPr>
          <p:grpSpPr>
            <a:xfrm>
              <a:off x="9140814" y="679299"/>
              <a:ext cx="2916000" cy="2483889"/>
              <a:chOff x="10666" y="59835"/>
              <a:chExt cx="2916000" cy="2483889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C4CD3FDF-ED7B-4090-A1EB-B17538A047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5129" r="2047"/>
              <a:stretch/>
            </p:blipFill>
            <p:spPr>
              <a:xfrm>
                <a:off x="10666" y="326148"/>
                <a:ext cx="2916000" cy="2217576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0BF02329-8BC5-47AE-85BD-41BE1D446863}"/>
                  </a:ext>
                </a:extLst>
              </p:cNvPr>
              <p:cNvSpPr txBox="1"/>
              <p:nvPr/>
            </p:nvSpPr>
            <p:spPr>
              <a:xfrm>
                <a:off x="1022596" y="59835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10</a:t>
                </a:r>
                <a:endParaRPr lang="en-US" dirty="0"/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79B9FAD7-98C8-41C4-A1BA-1EE1E00B5790}"/>
                </a:ext>
              </a:extLst>
            </p:cNvPr>
            <p:cNvGrpSpPr/>
            <p:nvPr/>
          </p:nvGrpSpPr>
          <p:grpSpPr>
            <a:xfrm>
              <a:off x="3180000" y="3429000"/>
              <a:ext cx="2916000" cy="2371052"/>
              <a:chOff x="6068402" y="91024"/>
              <a:chExt cx="2916000" cy="2371052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A48A8E26-51F3-4B7E-9010-647FADFF82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4098"/>
              <a:stretch/>
            </p:blipFill>
            <p:spPr>
              <a:xfrm>
                <a:off x="6068402" y="377095"/>
                <a:ext cx="2916000" cy="2084981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F0A7D80-5C9C-4E0E-A81B-28C87B057E8D}"/>
                  </a:ext>
                </a:extLst>
              </p:cNvPr>
              <p:cNvSpPr txBox="1"/>
              <p:nvPr/>
            </p:nvSpPr>
            <p:spPr>
              <a:xfrm>
                <a:off x="7077336" y="91024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17</a:t>
                </a:r>
                <a:endParaRPr lang="en-US" dirty="0"/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EDAF8715-65DC-4D48-8E15-6D6D49D160A5}"/>
                </a:ext>
              </a:extLst>
            </p:cNvPr>
            <p:cNvGrpSpPr/>
            <p:nvPr/>
          </p:nvGrpSpPr>
          <p:grpSpPr>
            <a:xfrm>
              <a:off x="0" y="3429000"/>
              <a:ext cx="2880000" cy="2507911"/>
              <a:chOff x="3057534" y="337085"/>
              <a:chExt cx="2880000" cy="2507911"/>
            </a:xfrm>
          </p:grpSpPr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0AD0225D-21B4-4DBB-8B9A-7E1912C6ED9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3487" t="4160" r="3624"/>
              <a:stretch/>
            </p:blipFill>
            <p:spPr>
              <a:xfrm>
                <a:off x="3057534" y="626664"/>
                <a:ext cx="2880000" cy="2218332"/>
              </a:xfrm>
              <a:prstGeom prst="rect">
                <a:avLst/>
              </a:prstGeom>
            </p:spPr>
          </p:pic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1E2B28A-873F-45BC-92F1-85826FD58DE2}"/>
                  </a:ext>
                </a:extLst>
              </p:cNvPr>
              <p:cNvSpPr txBox="1"/>
              <p:nvPr/>
            </p:nvSpPr>
            <p:spPr>
              <a:xfrm>
                <a:off x="3889162" y="337085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12</a:t>
                </a:r>
                <a:endParaRPr lang="en-US" dirty="0"/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D1CF9E78-9E4B-41B8-8BC6-37BFFEB581DD}"/>
                </a:ext>
              </a:extLst>
            </p:cNvPr>
            <p:cNvGrpSpPr/>
            <p:nvPr/>
          </p:nvGrpSpPr>
          <p:grpSpPr>
            <a:xfrm>
              <a:off x="6188311" y="3374916"/>
              <a:ext cx="2880000" cy="2376000"/>
              <a:chOff x="48000" y="3342884"/>
              <a:chExt cx="3024000" cy="2511018"/>
            </a:xfrm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3F0F4428-E4CA-408D-9ECC-C8876F9CBE7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t="4058" r="1592"/>
              <a:stretch/>
            </p:blipFill>
            <p:spPr>
              <a:xfrm>
                <a:off x="48000" y="3606848"/>
                <a:ext cx="3024000" cy="2247054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ABD77B89-EA4B-4B7C-951B-07AAE69CF2B1}"/>
                  </a:ext>
                </a:extLst>
              </p:cNvPr>
              <p:cNvSpPr txBox="1"/>
              <p:nvPr/>
            </p:nvSpPr>
            <p:spPr>
              <a:xfrm>
                <a:off x="1067592" y="3342884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31</a:t>
                </a:r>
                <a:endParaRPr lang="en-US" dirty="0"/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E1471D8B-14F6-4CAA-AA33-920812829B62}"/>
                </a:ext>
              </a:extLst>
            </p:cNvPr>
            <p:cNvGrpSpPr/>
            <p:nvPr/>
          </p:nvGrpSpPr>
          <p:grpSpPr>
            <a:xfrm>
              <a:off x="9140814" y="3319517"/>
              <a:ext cx="2916000" cy="2431399"/>
              <a:chOff x="8984402" y="91024"/>
              <a:chExt cx="2916000" cy="2431399"/>
            </a:xfrm>
          </p:grpSpPr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2F5D43E4-1F1A-47EB-81C6-5488B915625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t="4307"/>
              <a:stretch/>
            </p:blipFill>
            <p:spPr>
              <a:xfrm>
                <a:off x="8984402" y="377095"/>
                <a:ext cx="2916000" cy="2145328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BAFC3711-6F4F-48AA-9638-4501A6FD3136}"/>
                  </a:ext>
                </a:extLst>
              </p:cNvPr>
              <p:cNvSpPr txBox="1"/>
              <p:nvPr/>
            </p:nvSpPr>
            <p:spPr>
              <a:xfrm>
                <a:off x="9983600" y="91024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39</a:t>
                </a:r>
                <a:endParaRPr 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68220308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517E2DA-3457-4685-BE44-DC241144A198}"/>
              </a:ext>
            </a:extLst>
          </p:cNvPr>
          <p:cNvGrpSpPr/>
          <p:nvPr/>
        </p:nvGrpSpPr>
        <p:grpSpPr>
          <a:xfrm>
            <a:off x="-15867" y="642984"/>
            <a:ext cx="12207867" cy="5283030"/>
            <a:chOff x="-15867" y="642984"/>
            <a:chExt cx="12207867" cy="5283030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0C44F4C3-8FF6-40EA-879F-4825638CC372}"/>
                </a:ext>
              </a:extLst>
            </p:cNvPr>
            <p:cNvGrpSpPr/>
            <p:nvPr/>
          </p:nvGrpSpPr>
          <p:grpSpPr>
            <a:xfrm>
              <a:off x="0" y="642984"/>
              <a:ext cx="2916000" cy="2441903"/>
              <a:chOff x="0" y="2677443"/>
              <a:chExt cx="2916000" cy="2441903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C8361016-34C4-4AB4-93D0-45DA4BC198D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5883"/>
              <a:stretch/>
            </p:blipFill>
            <p:spPr>
              <a:xfrm>
                <a:off x="0" y="2931333"/>
                <a:ext cx="2916000" cy="2188013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10F5295-5C9B-4A76-9025-3D5BDF863E5A}"/>
                  </a:ext>
                </a:extLst>
              </p:cNvPr>
              <p:cNvSpPr txBox="1"/>
              <p:nvPr/>
            </p:nvSpPr>
            <p:spPr>
              <a:xfrm>
                <a:off x="989748" y="2677443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43</a:t>
                </a:r>
                <a:endParaRPr lang="en-US" dirty="0"/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565AF1A8-AED6-4A4C-9FE0-544850F9E108}"/>
                </a:ext>
              </a:extLst>
            </p:cNvPr>
            <p:cNvGrpSpPr/>
            <p:nvPr/>
          </p:nvGrpSpPr>
          <p:grpSpPr>
            <a:xfrm>
              <a:off x="9137667" y="738504"/>
              <a:ext cx="2916000" cy="2530753"/>
              <a:chOff x="2906264" y="2713752"/>
              <a:chExt cx="2916000" cy="2530753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D13797A7-EECF-4E3A-8A38-C85B49A71EE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4827" r="5359"/>
              <a:stretch/>
            </p:blipFill>
            <p:spPr>
              <a:xfrm>
                <a:off x="2906264" y="2977112"/>
                <a:ext cx="2916000" cy="2267393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7EB007B-B13A-463C-A25D-EB2972DE96AB}"/>
                  </a:ext>
                </a:extLst>
              </p:cNvPr>
              <p:cNvSpPr txBox="1"/>
              <p:nvPr/>
            </p:nvSpPr>
            <p:spPr>
              <a:xfrm>
                <a:off x="3742266" y="2713752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18</a:t>
                </a:r>
                <a:endParaRPr lang="en-US" dirty="0"/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6047F0F6-0669-43CC-970B-972272E86D78}"/>
                </a:ext>
              </a:extLst>
            </p:cNvPr>
            <p:cNvGrpSpPr/>
            <p:nvPr/>
          </p:nvGrpSpPr>
          <p:grpSpPr>
            <a:xfrm>
              <a:off x="-15867" y="3338777"/>
              <a:ext cx="2947734" cy="2552468"/>
              <a:chOff x="5812527" y="2677443"/>
              <a:chExt cx="3166998" cy="2585365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A3D88AD8-078B-4D39-A4F8-C15F58AE3EE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6679"/>
              <a:stretch/>
            </p:blipFill>
            <p:spPr>
              <a:xfrm>
                <a:off x="5812527" y="2958808"/>
                <a:ext cx="3166998" cy="2304000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A90BE8BA-5E20-4809-9863-266B5A15DE15}"/>
                  </a:ext>
                </a:extLst>
              </p:cNvPr>
              <p:cNvSpPr txBox="1"/>
              <p:nvPr/>
            </p:nvSpPr>
            <p:spPr>
              <a:xfrm>
                <a:off x="6904404" y="2677443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26</a:t>
                </a:r>
                <a:endParaRPr lang="en-US" dirty="0"/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B6EF422E-BE5A-471A-9631-3A0130047E5B}"/>
                </a:ext>
              </a:extLst>
            </p:cNvPr>
            <p:cNvGrpSpPr/>
            <p:nvPr/>
          </p:nvGrpSpPr>
          <p:grpSpPr>
            <a:xfrm>
              <a:off x="3117055" y="642984"/>
              <a:ext cx="2880000" cy="2465587"/>
              <a:chOff x="6034388" y="3388315"/>
              <a:chExt cx="3024000" cy="2465587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37266D51-D3A3-4931-8F12-8550C16A71F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2252" r="685"/>
              <a:stretch/>
            </p:blipFill>
            <p:spPr>
              <a:xfrm>
                <a:off x="6034388" y="3671034"/>
                <a:ext cx="3024000" cy="2182868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8D3FD475-0CD3-4A9D-92BC-4CEE1EEC69D6}"/>
                  </a:ext>
                </a:extLst>
              </p:cNvPr>
              <p:cNvSpPr txBox="1"/>
              <p:nvPr/>
            </p:nvSpPr>
            <p:spPr>
              <a:xfrm>
                <a:off x="7131462" y="3388315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50</a:t>
                </a:r>
                <a:endParaRPr lang="en-US" dirty="0"/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A04E0DBD-BF25-4188-818F-CFF4B8C348F2}"/>
                </a:ext>
              </a:extLst>
            </p:cNvPr>
            <p:cNvGrpSpPr/>
            <p:nvPr/>
          </p:nvGrpSpPr>
          <p:grpSpPr>
            <a:xfrm>
              <a:off x="6181091" y="666725"/>
              <a:ext cx="2880000" cy="2559596"/>
              <a:chOff x="9088092" y="3388315"/>
              <a:chExt cx="3024000" cy="2559596"/>
            </a:xfrm>
          </p:grpSpPr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6623D5F1-EA16-4DCC-8D89-A31BFCBBAEC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4064" r="2242"/>
              <a:stretch/>
            </p:blipFill>
            <p:spPr>
              <a:xfrm>
                <a:off x="9088092" y="3671034"/>
                <a:ext cx="3024000" cy="2276877"/>
              </a:xfrm>
              <a:prstGeom prst="rect">
                <a:avLst/>
              </a:prstGeom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69356441-A306-4475-B72E-FE3F30CC2D38}"/>
                  </a:ext>
                </a:extLst>
              </p:cNvPr>
              <p:cNvSpPr txBox="1"/>
              <p:nvPr/>
            </p:nvSpPr>
            <p:spPr>
              <a:xfrm>
                <a:off x="10227624" y="3388315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52</a:t>
                </a:r>
                <a:endParaRPr lang="en-US" dirty="0"/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757E2F71-8906-490A-9234-A27CAF7E0941}"/>
                </a:ext>
              </a:extLst>
            </p:cNvPr>
            <p:cNvGrpSpPr/>
            <p:nvPr/>
          </p:nvGrpSpPr>
          <p:grpSpPr>
            <a:xfrm>
              <a:off x="3050133" y="3298147"/>
              <a:ext cx="3060991" cy="2627867"/>
              <a:chOff x="8979525" y="2689244"/>
              <a:chExt cx="3060991" cy="2627867"/>
            </a:xfrm>
          </p:grpSpPr>
          <p:pic>
            <p:nvPicPr>
              <p:cNvPr id="35" name="Picture 34">
                <a:extLst>
                  <a:ext uri="{FF2B5EF4-FFF2-40B4-BE49-F238E27FC236}">
                    <a16:creationId xmlns:a16="http://schemas.microsoft.com/office/drawing/2014/main" id="{907E803C-09B1-46BD-9DF8-F438F67550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4423" t="4136" r="1987"/>
              <a:stretch/>
            </p:blipFill>
            <p:spPr>
              <a:xfrm>
                <a:off x="8979525" y="2977111"/>
                <a:ext cx="3060991" cy="2340000"/>
              </a:xfrm>
              <a:prstGeom prst="rect">
                <a:avLst/>
              </a:prstGeom>
            </p:spPr>
          </p:pic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6C98070C-B640-4B30-B96C-7DEE874C89BD}"/>
                  </a:ext>
                </a:extLst>
              </p:cNvPr>
              <p:cNvSpPr txBox="1"/>
              <p:nvPr/>
            </p:nvSpPr>
            <p:spPr>
              <a:xfrm>
                <a:off x="10032864" y="2689244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55</a:t>
                </a:r>
                <a:endParaRPr lang="en-US" dirty="0"/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EA347B21-A52F-46D1-9E0D-32D7F4F4261A}"/>
                </a:ext>
              </a:extLst>
            </p:cNvPr>
            <p:cNvGrpSpPr/>
            <p:nvPr/>
          </p:nvGrpSpPr>
          <p:grpSpPr>
            <a:xfrm>
              <a:off x="6266677" y="3338777"/>
              <a:ext cx="2916000" cy="2455074"/>
              <a:chOff x="0" y="389928"/>
              <a:chExt cx="2916000" cy="2455074"/>
            </a:xfrm>
          </p:grpSpPr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4E5DB367-E653-4887-AA93-2E8C5079F9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t="4290"/>
              <a:stretch/>
            </p:blipFill>
            <p:spPr>
              <a:xfrm>
                <a:off x="0" y="684043"/>
                <a:ext cx="2916000" cy="2160959"/>
              </a:xfrm>
              <a:prstGeom prst="rect">
                <a:avLst/>
              </a:prstGeom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8B0D0B53-02E3-4940-A4D9-A7F5F00F8F21}"/>
                  </a:ext>
                </a:extLst>
              </p:cNvPr>
              <p:cNvSpPr txBox="1"/>
              <p:nvPr/>
            </p:nvSpPr>
            <p:spPr>
              <a:xfrm>
                <a:off x="959886" y="389928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78</a:t>
                </a:r>
                <a:endParaRPr lang="en-US" dirty="0"/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E874528E-52EB-483A-8BCF-77E6952C6356}"/>
                </a:ext>
              </a:extLst>
            </p:cNvPr>
            <p:cNvGrpSpPr/>
            <p:nvPr/>
          </p:nvGrpSpPr>
          <p:grpSpPr>
            <a:xfrm>
              <a:off x="9168000" y="3307631"/>
              <a:ext cx="3024000" cy="2520746"/>
              <a:chOff x="2954409" y="103965"/>
              <a:chExt cx="3024000" cy="2520746"/>
            </a:xfrm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B89D0EF3-3445-438E-9C8A-689FA1F494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t="3732"/>
              <a:stretch/>
            </p:blipFill>
            <p:spPr>
              <a:xfrm>
                <a:off x="2954409" y="352479"/>
                <a:ext cx="3024000" cy="2272232"/>
              </a:xfrm>
              <a:prstGeom prst="rect">
                <a:avLst/>
              </a:prstGeom>
            </p:spPr>
          </p:pic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F52CC6FD-A899-47A7-9EC2-940D74D35166}"/>
                  </a:ext>
                </a:extLst>
              </p:cNvPr>
              <p:cNvSpPr txBox="1"/>
              <p:nvPr/>
            </p:nvSpPr>
            <p:spPr>
              <a:xfrm>
                <a:off x="4028816" y="103965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80</a:t>
                </a:r>
                <a:endParaRPr 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9807246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E591D03-5E96-4B7A-9E87-3B3A475B1D20}"/>
              </a:ext>
            </a:extLst>
          </p:cNvPr>
          <p:cNvGrpSpPr/>
          <p:nvPr/>
        </p:nvGrpSpPr>
        <p:grpSpPr>
          <a:xfrm>
            <a:off x="72043" y="131155"/>
            <a:ext cx="11974898" cy="2641644"/>
            <a:chOff x="72043" y="131155"/>
            <a:chExt cx="11974898" cy="2641644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5646499B-61F5-44CC-B516-7E27C24D9B42}"/>
                </a:ext>
              </a:extLst>
            </p:cNvPr>
            <p:cNvGrpSpPr/>
            <p:nvPr/>
          </p:nvGrpSpPr>
          <p:grpSpPr>
            <a:xfrm>
              <a:off x="72043" y="131155"/>
              <a:ext cx="2952000" cy="2524169"/>
              <a:chOff x="5978409" y="91683"/>
              <a:chExt cx="2952000" cy="2524169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88611931-343F-4F53-B2FD-0D2B9D632D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240" t="5644" r="487"/>
              <a:stretch/>
            </p:blipFill>
            <p:spPr>
              <a:xfrm>
                <a:off x="5978409" y="372534"/>
                <a:ext cx="2952000" cy="2243318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0725251-A387-4D8E-9E55-AD273829E813}"/>
                  </a:ext>
                </a:extLst>
              </p:cNvPr>
              <p:cNvSpPr txBox="1"/>
              <p:nvPr/>
            </p:nvSpPr>
            <p:spPr>
              <a:xfrm>
                <a:off x="6983225" y="91683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96</a:t>
                </a:r>
                <a:endParaRPr lang="en-US" dirty="0"/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BC94316F-41FB-4FB7-9F0E-ED033751BD7E}"/>
                </a:ext>
              </a:extLst>
            </p:cNvPr>
            <p:cNvGrpSpPr/>
            <p:nvPr/>
          </p:nvGrpSpPr>
          <p:grpSpPr>
            <a:xfrm>
              <a:off x="3143492" y="131155"/>
              <a:ext cx="2880000" cy="2583692"/>
              <a:chOff x="2757273" y="389928"/>
              <a:chExt cx="3140221" cy="2583692"/>
            </a:xfrm>
          </p:grpSpPr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7699688D-FE34-4253-A595-D0E7F229EC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6555"/>
              <a:stretch/>
            </p:blipFill>
            <p:spPr>
              <a:xfrm>
                <a:off x="2757273" y="655572"/>
                <a:ext cx="3140221" cy="2318048"/>
              </a:xfrm>
              <a:prstGeom prst="rect">
                <a:avLst/>
              </a:prstGeom>
            </p:spPr>
          </p:pic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86816C5D-9C34-4E1C-B708-58E14777025E}"/>
                  </a:ext>
                </a:extLst>
              </p:cNvPr>
              <p:cNvSpPr txBox="1"/>
              <p:nvPr/>
            </p:nvSpPr>
            <p:spPr>
              <a:xfrm>
                <a:off x="3788002" y="389928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334</a:t>
                </a:r>
                <a:endParaRPr lang="en-US" dirty="0"/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431E9407-74F4-45DB-9386-E35DE8445A1A}"/>
                </a:ext>
              </a:extLst>
            </p:cNvPr>
            <p:cNvGrpSpPr/>
            <p:nvPr/>
          </p:nvGrpSpPr>
          <p:grpSpPr>
            <a:xfrm>
              <a:off x="6214941" y="173430"/>
              <a:ext cx="2880000" cy="2536610"/>
              <a:chOff x="5903999" y="389928"/>
              <a:chExt cx="2952000" cy="2536610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B82372DB-C4E4-4CBB-9E51-3ECD226D67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6944" r="3460"/>
              <a:stretch/>
            </p:blipFill>
            <p:spPr>
              <a:xfrm>
                <a:off x="5903999" y="684043"/>
                <a:ext cx="2952000" cy="2242495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A63673F-7A8F-41D8-8AFB-57B2C6582F0E}"/>
                  </a:ext>
                </a:extLst>
              </p:cNvPr>
              <p:cNvSpPr txBox="1"/>
              <p:nvPr/>
            </p:nvSpPr>
            <p:spPr>
              <a:xfrm>
                <a:off x="6848002" y="389928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385</a:t>
                </a:r>
                <a:endParaRPr lang="en-US" dirty="0"/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2E819608-4540-4CC1-9804-D58264271447}"/>
                </a:ext>
              </a:extLst>
            </p:cNvPr>
            <p:cNvGrpSpPr/>
            <p:nvPr/>
          </p:nvGrpSpPr>
          <p:grpSpPr>
            <a:xfrm>
              <a:off x="9094941" y="220734"/>
              <a:ext cx="2952000" cy="2552065"/>
              <a:chOff x="8891998" y="389928"/>
              <a:chExt cx="2952000" cy="2552065"/>
            </a:xfrm>
          </p:grpSpPr>
          <p:pic>
            <p:nvPicPr>
              <p:cNvPr id="20" name="Picture 19">
                <a:extLst>
                  <a:ext uri="{FF2B5EF4-FFF2-40B4-BE49-F238E27FC236}">
                    <a16:creationId xmlns:a16="http://schemas.microsoft.com/office/drawing/2014/main" id="{074DC6BA-C397-4BB6-958A-9239B1B476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5278" r="1786"/>
              <a:stretch/>
            </p:blipFill>
            <p:spPr>
              <a:xfrm>
                <a:off x="8891998" y="655572"/>
                <a:ext cx="2952000" cy="2286421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E8D0E649-924B-46C6-8032-B0EED4F3F0AC}"/>
                  </a:ext>
                </a:extLst>
              </p:cNvPr>
              <p:cNvSpPr txBox="1"/>
              <p:nvPr/>
            </p:nvSpPr>
            <p:spPr>
              <a:xfrm>
                <a:off x="9951318" y="389928"/>
                <a:ext cx="12439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437</a:t>
                </a:r>
                <a:endParaRPr lang="en-US" dirty="0"/>
              </a:p>
            </p:txBody>
          </p:sp>
        </p:grpSp>
      </p:grpSp>
      <p:sp>
        <p:nvSpPr>
          <p:cNvPr id="4" name="Rectangle 3">
            <a:extLst>
              <a:ext uri="{FF2B5EF4-FFF2-40B4-BE49-F238E27FC236}">
                <a16:creationId xmlns:a16="http://schemas.microsoft.com/office/drawing/2014/main" id="{31EF31B4-5EF8-4F7F-9E04-6A697CEFCD0D}"/>
              </a:ext>
            </a:extLst>
          </p:cNvPr>
          <p:cNvSpPr/>
          <p:nvPr/>
        </p:nvSpPr>
        <p:spPr>
          <a:xfrm>
            <a:off x="1459774" y="3038443"/>
            <a:ext cx="912743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dirty="0"/>
              <a:t> Tanimoto Coefficient Similarity Distribution for compounds in significant clusters. </a:t>
            </a:r>
          </a:p>
          <a:p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92645981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D95FE50-E873-424A-AD1A-88ADD40E6768}"/>
              </a:ext>
            </a:extLst>
          </p:cNvPr>
          <p:cNvGrpSpPr/>
          <p:nvPr/>
        </p:nvGrpSpPr>
        <p:grpSpPr>
          <a:xfrm>
            <a:off x="435608" y="999029"/>
            <a:ext cx="11320784" cy="3702155"/>
            <a:chOff x="31624" y="67696"/>
            <a:chExt cx="11320784" cy="370215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8530B57-6632-4DF8-8A79-4026403272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34294" b="36072"/>
            <a:stretch/>
          </p:blipFill>
          <p:spPr>
            <a:xfrm>
              <a:off x="78737" y="220138"/>
              <a:ext cx="2561800" cy="75914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967B640-6310-4F3C-A914-BC4121D134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0070" b="20959"/>
            <a:stretch/>
          </p:blipFill>
          <p:spPr>
            <a:xfrm>
              <a:off x="2759534" y="113589"/>
              <a:ext cx="1648704" cy="97224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C429A65-576B-4AFE-861F-0A5C1013AE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587" t="22441" b="23626"/>
            <a:stretch/>
          </p:blipFill>
          <p:spPr>
            <a:xfrm>
              <a:off x="4584279" y="67696"/>
              <a:ext cx="1896271" cy="104986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E047760-EC4A-4CB7-AD50-2ED5C40C19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883" t="25700" b="25108"/>
            <a:stretch/>
          </p:blipFill>
          <p:spPr>
            <a:xfrm>
              <a:off x="6772432" y="113589"/>
              <a:ext cx="1838703" cy="931333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E29BF453-FD5E-4B0F-AFBF-E06A0AC5DB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883" t="32516" b="33455"/>
            <a:stretch/>
          </p:blipFill>
          <p:spPr>
            <a:xfrm>
              <a:off x="8972875" y="85246"/>
              <a:ext cx="2379533" cy="83376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1B66E51F-8FAB-462B-A00C-4E673180CC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32436" b="33535"/>
            <a:stretch/>
          </p:blipFill>
          <p:spPr>
            <a:xfrm>
              <a:off x="31624" y="1567608"/>
              <a:ext cx="2189266" cy="744977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4DD7851-9180-402F-BEB3-9651A78DFA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3180" t="29880" r="2586" b="31251"/>
            <a:stretch/>
          </p:blipFill>
          <p:spPr>
            <a:xfrm>
              <a:off x="2470004" y="1553437"/>
              <a:ext cx="1840460" cy="759148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72F5364E-7972-4862-A221-94696D12C5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2587" t="31385" b="31870"/>
            <a:stretch/>
          </p:blipFill>
          <p:spPr>
            <a:xfrm>
              <a:off x="4495011" y="1416421"/>
              <a:ext cx="2117752" cy="798838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02A670C-9566-4CFB-911D-066190C1C8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25161" b="25997"/>
            <a:stretch/>
          </p:blipFill>
          <p:spPr>
            <a:xfrm>
              <a:off x="6599547" y="1117562"/>
              <a:ext cx="2247448" cy="1097697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03745490-1657-49F9-A89C-AC60BFACE9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845" t="28713" b="26645"/>
            <a:stretch/>
          </p:blipFill>
          <p:spPr>
            <a:xfrm>
              <a:off x="9031542" y="1180287"/>
              <a:ext cx="2115941" cy="972246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12F6F2C9-1626-4747-A349-B0AFFC8335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3316" t="27609" r="3338" b="27941"/>
            <a:stretch/>
          </p:blipFill>
          <p:spPr>
            <a:xfrm>
              <a:off x="108386" y="2610941"/>
              <a:ext cx="2281800" cy="1086571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0DE74BA6-FE9F-4DA0-BE6A-5008339BC5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l="3168" t="20551" b="21606"/>
            <a:stretch/>
          </p:blipFill>
          <p:spPr>
            <a:xfrm>
              <a:off x="2607317" y="2670426"/>
              <a:ext cx="1840460" cy="1099425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7DF33592-8B85-4E7F-8815-B064EFB2AD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29278" b="29407"/>
            <a:stretch/>
          </p:blipFill>
          <p:spPr>
            <a:xfrm>
              <a:off x="4758992" y="2783029"/>
              <a:ext cx="2115941" cy="874218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EC3280DC-BE39-4EED-8A2A-A1ECD1FE69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/>
            <a:srcRect l="3955" t="16945" b="18188"/>
            <a:stretch/>
          </p:blipFill>
          <p:spPr>
            <a:xfrm>
              <a:off x="7186148" y="2382496"/>
              <a:ext cx="1781015" cy="1202867"/>
            </a:xfrm>
            <a:prstGeom prst="rect">
              <a:avLst/>
            </a:prstGeom>
          </p:spPr>
        </p:pic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82020085-8E6F-4FD9-96E9-3AD5F9120A3B}"/>
              </a:ext>
            </a:extLst>
          </p:cNvPr>
          <p:cNvSpPr/>
          <p:nvPr/>
        </p:nvSpPr>
        <p:spPr>
          <a:xfrm>
            <a:off x="1763622" y="5141690"/>
            <a:ext cx="725149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r>
              <a:rPr lang="en-US" dirty="0"/>
              <a:t> List of the most common scaffolds identified within each cluster. </a:t>
            </a:r>
          </a:p>
        </p:txBody>
      </p:sp>
    </p:spTree>
    <p:extLst>
      <p:ext uri="{BB962C8B-B14F-4D97-AF65-F5344CB8AC3E}">
        <p14:creationId xmlns:p14="http://schemas.microsoft.com/office/powerpoint/2010/main" val="12545758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EC8BFA10-6D7D-465E-BAB9-99C52999754F}"/>
              </a:ext>
            </a:extLst>
          </p:cNvPr>
          <p:cNvSpPr/>
          <p:nvPr/>
        </p:nvSpPr>
        <p:spPr>
          <a:xfrm>
            <a:off x="8370198" y="3133962"/>
            <a:ext cx="360159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-Radomerization model. For all models, 20% of the data were randomized, and the models were constructed using the same parameters as those applied to the original dataset. 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955F1BA-E0C9-437B-91F6-F2365EFF6BDE}"/>
              </a:ext>
            </a:extLst>
          </p:cNvPr>
          <p:cNvGrpSpPr/>
          <p:nvPr/>
        </p:nvGrpSpPr>
        <p:grpSpPr>
          <a:xfrm>
            <a:off x="331149" y="166134"/>
            <a:ext cx="7493067" cy="6361201"/>
            <a:chOff x="235828" y="43768"/>
            <a:chExt cx="7493067" cy="6361201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340D3134-4C0A-48C3-8EBE-039D8E70A3A4}"/>
                </a:ext>
              </a:extLst>
            </p:cNvPr>
            <p:cNvGrpSpPr/>
            <p:nvPr/>
          </p:nvGrpSpPr>
          <p:grpSpPr>
            <a:xfrm>
              <a:off x="4272463" y="3411706"/>
              <a:ext cx="3456432" cy="2993263"/>
              <a:chOff x="4401804" y="3536335"/>
              <a:chExt cx="3456432" cy="2993263"/>
            </a:xfrm>
          </p:grpSpPr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F2A7B9B4-8DB3-4579-BC3B-B577540035D8}"/>
                  </a:ext>
                </a:extLst>
              </p:cNvPr>
              <p:cNvSpPr txBox="1"/>
              <p:nvPr/>
            </p:nvSpPr>
            <p:spPr>
              <a:xfrm>
                <a:off x="5813573" y="3536335"/>
                <a:ext cx="5982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MLP</a:t>
                </a:r>
                <a:endParaRPr lang="en-US" dirty="0"/>
              </a:p>
            </p:txBody>
          </p:sp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id="{B76A4043-0E4C-44D2-A036-A60A7E362C38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82" t="10528" r="9209" b="3889"/>
              <a:stretch/>
            </p:blipFill>
            <p:spPr>
              <a:xfrm>
                <a:off x="4401804" y="3832118"/>
                <a:ext cx="3456432" cy="2697480"/>
              </a:xfrm>
              <a:prstGeom prst="rect">
                <a:avLst/>
              </a:prstGeom>
            </p:spPr>
          </p:pic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EE72F015-DC16-40E5-8F17-29825BCCA304}"/>
                </a:ext>
              </a:extLst>
            </p:cNvPr>
            <p:cNvGrpSpPr/>
            <p:nvPr/>
          </p:nvGrpSpPr>
          <p:grpSpPr>
            <a:xfrm>
              <a:off x="235828" y="3395694"/>
              <a:ext cx="3456000" cy="3009275"/>
              <a:chOff x="405162" y="3465866"/>
              <a:chExt cx="3456000" cy="3009275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B6DF58F-BB8C-4CB3-B3F1-2FFD50C2CF31}"/>
                  </a:ext>
                </a:extLst>
              </p:cNvPr>
              <p:cNvSpPr txBox="1"/>
              <p:nvPr/>
            </p:nvSpPr>
            <p:spPr>
              <a:xfrm>
                <a:off x="1719028" y="3465866"/>
                <a:ext cx="97629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XGBoost</a:t>
                </a:r>
                <a:endParaRPr lang="en-US" dirty="0"/>
              </a:p>
            </p:txBody>
          </p:sp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2B705574-1C96-4E9A-B906-99B78561E644}"/>
                  </a:ext>
                </a:extLst>
              </p:cNvPr>
              <p:cNvPicPr>
                <a:picLocks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05162" y="3777661"/>
                <a:ext cx="3456000" cy="2697480"/>
              </a:xfrm>
              <a:prstGeom prst="rect">
                <a:avLst/>
              </a:prstGeom>
            </p:spPr>
          </p:pic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55255DB2-DFD9-4871-9F45-F14BAA24EDC5}"/>
                </a:ext>
              </a:extLst>
            </p:cNvPr>
            <p:cNvGrpSpPr/>
            <p:nvPr/>
          </p:nvGrpSpPr>
          <p:grpSpPr>
            <a:xfrm>
              <a:off x="235828" y="48166"/>
              <a:ext cx="3456000" cy="3018106"/>
              <a:chOff x="235828" y="48166"/>
              <a:chExt cx="3456000" cy="3018106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DF9D6F9-E24D-4468-8908-643E72C6FC5E}"/>
                  </a:ext>
                </a:extLst>
              </p:cNvPr>
              <p:cNvSpPr txBox="1"/>
              <p:nvPr/>
            </p:nvSpPr>
            <p:spPr>
              <a:xfrm>
                <a:off x="1729101" y="48166"/>
                <a:ext cx="6174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SVM</a:t>
                </a:r>
                <a:endParaRPr lang="en-US" dirty="0"/>
              </a:p>
            </p:txBody>
          </p:sp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760ACDA2-9D66-4DE5-A220-1623FC8037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11" t="11374" r="9477" b="3553"/>
              <a:stretch/>
            </p:blipFill>
            <p:spPr>
              <a:xfrm>
                <a:off x="235828" y="366128"/>
                <a:ext cx="3456000" cy="2700144"/>
              </a:xfrm>
              <a:prstGeom prst="rect">
                <a:avLst/>
              </a:prstGeom>
            </p:spPr>
          </p:pic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F309A647-82F4-4A0A-8203-576FAAD7DA7F}"/>
                </a:ext>
              </a:extLst>
            </p:cNvPr>
            <p:cNvGrpSpPr/>
            <p:nvPr/>
          </p:nvGrpSpPr>
          <p:grpSpPr>
            <a:xfrm>
              <a:off x="4255353" y="43768"/>
              <a:ext cx="3456000" cy="3022504"/>
              <a:chOff x="4384694" y="66802"/>
              <a:chExt cx="3456000" cy="3022504"/>
            </a:xfrm>
          </p:grpSpPr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40629F02-C8C0-4887-8F0A-20BCAF59E8BC}"/>
                  </a:ext>
                </a:extLst>
              </p:cNvPr>
              <p:cNvSpPr txBox="1"/>
              <p:nvPr/>
            </p:nvSpPr>
            <p:spPr>
              <a:xfrm>
                <a:off x="5904945" y="66802"/>
                <a:ext cx="4154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IN" dirty="0"/>
                  <a:t>RF</a:t>
                </a:r>
                <a:endParaRPr lang="en-US" dirty="0"/>
              </a:p>
            </p:txBody>
          </p:sp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B258821B-03FC-40DF-AA52-632FF5F8D20A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07" t="11599" r="9738" b="3368"/>
              <a:stretch/>
            </p:blipFill>
            <p:spPr>
              <a:xfrm>
                <a:off x="4384694" y="388715"/>
                <a:ext cx="3456000" cy="2700591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4972507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9C8B6F25-8B5C-4F75-B290-B02E6D7F9E2E}"/>
              </a:ext>
            </a:extLst>
          </p:cNvPr>
          <p:cNvGrpSpPr/>
          <p:nvPr/>
        </p:nvGrpSpPr>
        <p:grpSpPr>
          <a:xfrm>
            <a:off x="206781" y="0"/>
            <a:ext cx="7504074" cy="6305081"/>
            <a:chOff x="130581" y="-33765"/>
            <a:chExt cx="7504074" cy="6305081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7AE0BA31-7FE4-44BF-A8DA-B134864C430D}"/>
                </a:ext>
              </a:extLst>
            </p:cNvPr>
            <p:cNvGrpSpPr/>
            <p:nvPr/>
          </p:nvGrpSpPr>
          <p:grpSpPr>
            <a:xfrm>
              <a:off x="237063" y="-13732"/>
              <a:ext cx="3572933" cy="3188732"/>
              <a:chOff x="237065" y="147134"/>
              <a:chExt cx="3572933" cy="3188732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2BFFA2C6-1ED9-40A5-B936-A8C4148720E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81" t="11605" r="9407"/>
              <a:stretch/>
            </p:blipFill>
            <p:spPr>
              <a:xfrm>
                <a:off x="237065" y="432098"/>
                <a:ext cx="3572933" cy="2903768"/>
              </a:xfrm>
              <a:prstGeom prst="rect">
                <a:avLst/>
              </a:prstGeom>
            </p:spPr>
          </p:pic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E5889DB8-6E85-474A-BA17-9CB1F60A9D37}"/>
                  </a:ext>
                </a:extLst>
              </p:cNvPr>
              <p:cNvSpPr txBox="1"/>
              <p:nvPr/>
            </p:nvSpPr>
            <p:spPr>
              <a:xfrm>
                <a:off x="1714792" y="147134"/>
                <a:ext cx="61747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SVM</a:t>
                </a:r>
                <a:endParaRPr lang="en-US" dirty="0"/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446CC564-AF02-40D9-9400-0767CBF37E7F}"/>
                </a:ext>
              </a:extLst>
            </p:cNvPr>
            <p:cNvGrpSpPr/>
            <p:nvPr/>
          </p:nvGrpSpPr>
          <p:grpSpPr>
            <a:xfrm>
              <a:off x="3892388" y="-33765"/>
              <a:ext cx="3657600" cy="3123658"/>
              <a:chOff x="4216400" y="132664"/>
              <a:chExt cx="3657600" cy="3123658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3B5C818E-5BC3-429A-ADC2-1B45BA5539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81" t="11481" r="9185" b="4321"/>
              <a:stretch/>
            </p:blipFill>
            <p:spPr>
              <a:xfrm>
                <a:off x="4216400" y="432097"/>
                <a:ext cx="3657600" cy="2824225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1FE8CE8D-72C5-46D5-A588-0249C60268E9}"/>
                  </a:ext>
                </a:extLst>
              </p:cNvPr>
              <p:cNvSpPr txBox="1"/>
              <p:nvPr/>
            </p:nvSpPr>
            <p:spPr>
              <a:xfrm>
                <a:off x="6045200" y="132664"/>
                <a:ext cx="4154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RF</a:t>
                </a:r>
                <a:endParaRPr lang="en-US" dirty="0"/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238267B4-7C1E-4AA6-9CA0-D1CF0BCB2D04}"/>
                </a:ext>
              </a:extLst>
            </p:cNvPr>
            <p:cNvGrpSpPr/>
            <p:nvPr/>
          </p:nvGrpSpPr>
          <p:grpSpPr>
            <a:xfrm>
              <a:off x="130581" y="3032472"/>
              <a:ext cx="3720611" cy="3238844"/>
              <a:chOff x="163225" y="3395133"/>
              <a:chExt cx="3720611" cy="3238844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40EDFB2C-24FF-4759-8A6C-DC26970E0B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73" t="11233" r="9507" b="3087"/>
              <a:stretch/>
            </p:blipFill>
            <p:spPr>
              <a:xfrm>
                <a:off x="163225" y="3683000"/>
                <a:ext cx="3720611" cy="2950977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3C07D1DB-3497-4891-94C2-59431E84A6D5}"/>
                  </a:ext>
                </a:extLst>
              </p:cNvPr>
              <p:cNvSpPr txBox="1"/>
              <p:nvPr/>
            </p:nvSpPr>
            <p:spPr>
              <a:xfrm>
                <a:off x="1693915" y="3395133"/>
                <a:ext cx="97629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XGBoost</a:t>
                </a:r>
                <a:endParaRPr lang="en-US" dirty="0"/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D77B033A-E064-4476-82DD-24831CE1C2B0}"/>
                </a:ext>
              </a:extLst>
            </p:cNvPr>
            <p:cNvGrpSpPr/>
            <p:nvPr/>
          </p:nvGrpSpPr>
          <p:grpSpPr>
            <a:xfrm>
              <a:off x="3892388" y="3049405"/>
              <a:ext cx="3742267" cy="3209852"/>
              <a:chOff x="4216400" y="3424125"/>
              <a:chExt cx="3742267" cy="3209852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ACD65E8D-0BB3-435C-829B-12A65CAA85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216400" y="3683000"/>
                <a:ext cx="3742267" cy="2950977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39413EC-6789-44BD-9FCA-720C7A0DD36D}"/>
                  </a:ext>
                </a:extLst>
              </p:cNvPr>
              <p:cNvSpPr txBox="1"/>
              <p:nvPr/>
            </p:nvSpPr>
            <p:spPr>
              <a:xfrm>
                <a:off x="6042921" y="3424125"/>
                <a:ext cx="5982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MLP</a:t>
                </a:r>
                <a:endParaRPr lang="en-US" dirty="0"/>
              </a:p>
            </p:txBody>
          </p:sp>
        </p:grpSp>
      </p:grpSp>
      <p:sp>
        <p:nvSpPr>
          <p:cNvPr id="15" name="Rectangle 14">
            <a:extLst>
              <a:ext uri="{FF2B5EF4-FFF2-40B4-BE49-F238E27FC236}">
                <a16:creationId xmlns:a16="http://schemas.microsoft.com/office/drawing/2014/main" id="{47A1A918-F76F-4F78-A3D8-096536376A5C}"/>
              </a:ext>
            </a:extLst>
          </p:cNvPr>
          <p:cNvSpPr/>
          <p:nvPr/>
        </p:nvSpPr>
        <p:spPr>
          <a:xfrm>
            <a:off x="8092658" y="2623989"/>
            <a:ext cx="349280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-Radomerization model for ECFPs. For all models, 20% of the data were randomized, and the models were constructed using the same parameters as those applied to the original dataset. </a:t>
            </a:r>
          </a:p>
        </p:txBody>
      </p:sp>
    </p:spTree>
    <p:extLst>
      <p:ext uri="{BB962C8B-B14F-4D97-AF65-F5344CB8AC3E}">
        <p14:creationId xmlns:p14="http://schemas.microsoft.com/office/powerpoint/2010/main" val="25235992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0A7C060B-55F2-4228-8F17-9E605B39B7BA}"/>
              </a:ext>
            </a:extLst>
          </p:cNvPr>
          <p:cNvSpPr txBox="1"/>
          <p:nvPr/>
        </p:nvSpPr>
        <p:spPr>
          <a:xfrm>
            <a:off x="10488695" y="315688"/>
            <a:ext cx="1126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/>
              <a:t>Cluster 14</a:t>
            </a:r>
            <a:endParaRPr lang="en-US" dirty="0"/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3C474C92-A24C-4036-9B7E-6F90F774D56B}"/>
              </a:ext>
            </a:extLst>
          </p:cNvPr>
          <p:cNvGrpSpPr/>
          <p:nvPr/>
        </p:nvGrpSpPr>
        <p:grpSpPr>
          <a:xfrm>
            <a:off x="17178" y="173012"/>
            <a:ext cx="11835006" cy="6653971"/>
            <a:chOff x="17178" y="173012"/>
            <a:chExt cx="11835006" cy="6653971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2002C134-B634-4694-B674-3A69CDE0D8E3}"/>
                </a:ext>
              </a:extLst>
            </p:cNvPr>
            <p:cNvGrpSpPr/>
            <p:nvPr/>
          </p:nvGrpSpPr>
          <p:grpSpPr>
            <a:xfrm>
              <a:off x="17178" y="173012"/>
              <a:ext cx="11759010" cy="3341131"/>
              <a:chOff x="17178" y="173012"/>
              <a:chExt cx="11759010" cy="3341131"/>
            </a:xfrm>
          </p:grpSpPr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83B9CC5D-264D-4E91-A8C2-E090D98A4EF3}"/>
                  </a:ext>
                </a:extLst>
              </p:cNvPr>
              <p:cNvGrpSpPr/>
              <p:nvPr/>
            </p:nvGrpSpPr>
            <p:grpSpPr>
              <a:xfrm>
                <a:off x="17178" y="272535"/>
                <a:ext cx="2760593" cy="3056942"/>
                <a:chOff x="127000" y="498501"/>
                <a:chExt cx="2971798" cy="3056942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02F6AEE7-E2C0-437D-AC8C-6AF78F39DE4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790" t="6544" r="7037" b="7283"/>
                <a:stretch/>
              </p:blipFill>
              <p:spPr>
                <a:xfrm>
                  <a:off x="127000" y="583644"/>
                  <a:ext cx="2971798" cy="2971799"/>
                </a:xfrm>
                <a:prstGeom prst="rect">
                  <a:avLst/>
                </a:prstGeom>
              </p:spPr>
            </p:pic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BB146161-DDD9-4C04-81D1-1A0DB9D5399E}"/>
                    </a:ext>
                  </a:extLst>
                </p:cNvPr>
                <p:cNvSpPr txBox="1"/>
                <p:nvPr/>
              </p:nvSpPr>
              <p:spPr>
                <a:xfrm>
                  <a:off x="728931" y="498501"/>
                  <a:ext cx="112697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dirty="0"/>
                    <a:t>Cluster 10</a:t>
                  </a:r>
                  <a:endParaRPr lang="en-US" dirty="0"/>
                </a:p>
              </p:txBody>
            </p:sp>
          </p:grp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A6D6DB84-2463-41A7-9839-C7D7A71171B7}"/>
                  </a:ext>
                </a:extLst>
              </p:cNvPr>
              <p:cNvGrpSpPr/>
              <p:nvPr/>
            </p:nvGrpSpPr>
            <p:grpSpPr>
              <a:xfrm>
                <a:off x="2937457" y="252440"/>
                <a:ext cx="2633583" cy="3169653"/>
                <a:chOff x="2929454" y="87869"/>
                <a:chExt cx="2760136" cy="3369651"/>
              </a:xfrm>
            </p:grpSpPr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131C6985-1709-48D3-8011-F08A72FF45A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161" t="6396" r="6666" b="6937"/>
                <a:stretch/>
              </p:blipFill>
              <p:spPr>
                <a:xfrm flipH="1">
                  <a:off x="2929454" y="681566"/>
                  <a:ext cx="2760136" cy="2775954"/>
                </a:xfrm>
                <a:prstGeom prst="rect">
                  <a:avLst/>
                </a:prstGeom>
              </p:spPr>
            </p:pic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32E1D3DA-CB70-46A5-9A52-799C31DC6E4D}"/>
                    </a:ext>
                  </a:extLst>
                </p:cNvPr>
                <p:cNvSpPr txBox="1"/>
                <p:nvPr/>
              </p:nvSpPr>
              <p:spPr>
                <a:xfrm>
                  <a:off x="3267219" y="87869"/>
                  <a:ext cx="112697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dirty="0"/>
                    <a:t>Cluster 11</a:t>
                  </a:r>
                  <a:endParaRPr lang="en-US" dirty="0"/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7F37A22E-D782-444B-9376-9FA5C7F8EAC1}"/>
                  </a:ext>
                </a:extLst>
              </p:cNvPr>
              <p:cNvGrpSpPr/>
              <p:nvPr/>
            </p:nvGrpSpPr>
            <p:grpSpPr>
              <a:xfrm>
                <a:off x="5641779" y="173012"/>
                <a:ext cx="2870209" cy="3341131"/>
                <a:chOff x="5725566" y="-54807"/>
                <a:chExt cx="2870209" cy="3341131"/>
              </a:xfrm>
            </p:grpSpPr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0D29587F-E9AD-48DA-B9D0-0E3BE1F6BDF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284" t="7099" r="7037" b="7160"/>
                <a:stretch/>
              </p:blipFill>
              <p:spPr>
                <a:xfrm flipH="1">
                  <a:off x="5725566" y="414048"/>
                  <a:ext cx="2870209" cy="2872276"/>
                </a:xfrm>
                <a:prstGeom prst="rect">
                  <a:avLst/>
                </a:prstGeom>
              </p:spPr>
            </p:pic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D3ECF17B-2AAA-443B-87E7-A7AA619D01BF}"/>
                    </a:ext>
                  </a:extLst>
                </p:cNvPr>
                <p:cNvSpPr txBox="1"/>
                <p:nvPr/>
              </p:nvSpPr>
              <p:spPr>
                <a:xfrm>
                  <a:off x="6561206" y="-54807"/>
                  <a:ext cx="1126975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dirty="0"/>
                    <a:t>Cluster 12</a:t>
                  </a:r>
                  <a:endParaRPr lang="en-US" dirty="0"/>
                </a:p>
              </p:txBody>
            </p:sp>
          </p:grpSp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4B43F538-B17C-4D3B-B2CE-6EA51EB802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38" t="6666" r="6420" b="6543"/>
              <a:stretch/>
            </p:blipFill>
            <p:spPr>
              <a:xfrm>
                <a:off x="9201202" y="641867"/>
                <a:ext cx="2574986" cy="2582332"/>
              </a:xfrm>
              <a:prstGeom prst="rect">
                <a:avLst/>
              </a:prstGeom>
            </p:spPr>
          </p:pic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4891ED9C-EB24-4A7F-8641-76D8882FF57F}"/>
                </a:ext>
              </a:extLst>
            </p:cNvPr>
            <p:cNvGrpSpPr/>
            <p:nvPr/>
          </p:nvGrpSpPr>
          <p:grpSpPr>
            <a:xfrm>
              <a:off x="246834" y="3542264"/>
              <a:ext cx="2530937" cy="2958058"/>
              <a:chOff x="246834" y="3542264"/>
              <a:chExt cx="2530937" cy="2958058"/>
            </a:xfrm>
          </p:grpSpPr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AC7C0987-8276-4A73-81D0-ACAEA62571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96" t="7037" r="5926" b="6173"/>
              <a:stretch/>
            </p:blipFill>
            <p:spPr>
              <a:xfrm>
                <a:off x="246834" y="3997863"/>
                <a:ext cx="2530937" cy="2502459"/>
              </a:xfrm>
              <a:prstGeom prst="rect">
                <a:avLst/>
              </a:prstGeom>
            </p:spPr>
          </p:pic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1A86E41-77AF-4974-9FC1-C7D524A0E98B}"/>
                  </a:ext>
                </a:extLst>
              </p:cNvPr>
              <p:cNvSpPr txBox="1"/>
              <p:nvPr/>
            </p:nvSpPr>
            <p:spPr>
              <a:xfrm>
                <a:off x="385327" y="3542264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1</a:t>
                </a:r>
                <a:endParaRPr lang="en-US" dirty="0"/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A8612728-D90D-4032-9A76-E3D2856764B7}"/>
                </a:ext>
              </a:extLst>
            </p:cNvPr>
            <p:cNvGrpSpPr/>
            <p:nvPr/>
          </p:nvGrpSpPr>
          <p:grpSpPr>
            <a:xfrm>
              <a:off x="2777771" y="3782179"/>
              <a:ext cx="2172530" cy="2553841"/>
              <a:chOff x="2777771" y="3782179"/>
              <a:chExt cx="2172530" cy="2553841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51D23AD0-AE42-4615-B1C2-F0D94DC741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623" t="7096" r="6392" b="6867"/>
              <a:stretch/>
            </p:blipFill>
            <p:spPr>
              <a:xfrm>
                <a:off x="2777771" y="4162164"/>
                <a:ext cx="2172530" cy="2173856"/>
              </a:xfrm>
              <a:prstGeom prst="rect">
                <a:avLst/>
              </a:prstGeom>
            </p:spPr>
          </p:pic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812A9FCB-8AE0-4F3C-A353-014FD612C5E8}"/>
                  </a:ext>
                </a:extLst>
              </p:cNvPr>
              <p:cNvSpPr txBox="1"/>
              <p:nvPr/>
            </p:nvSpPr>
            <p:spPr>
              <a:xfrm>
                <a:off x="3619977" y="3782179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3</a:t>
                </a:r>
                <a:endParaRPr lang="en-US" dirty="0"/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CF1361CE-4A10-4198-B2B0-6129697872D9}"/>
                </a:ext>
              </a:extLst>
            </p:cNvPr>
            <p:cNvGrpSpPr/>
            <p:nvPr/>
          </p:nvGrpSpPr>
          <p:grpSpPr>
            <a:xfrm>
              <a:off x="5409921" y="3717684"/>
              <a:ext cx="2889412" cy="3109299"/>
              <a:chOff x="5409921" y="3717684"/>
              <a:chExt cx="2889412" cy="3109299"/>
            </a:xfrm>
          </p:grpSpPr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30EC04E4-33FA-427E-BF89-A25AB191647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08" t="6877" r="6624" b="7037"/>
              <a:stretch/>
            </p:blipFill>
            <p:spPr>
              <a:xfrm>
                <a:off x="5409921" y="3966845"/>
                <a:ext cx="2889412" cy="2860138"/>
              </a:xfrm>
              <a:prstGeom prst="rect">
                <a:avLst/>
              </a:prstGeom>
            </p:spPr>
          </p:pic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CF897691-7498-476E-9FE2-DB92D8F51796}"/>
                  </a:ext>
                </a:extLst>
              </p:cNvPr>
              <p:cNvSpPr txBox="1"/>
              <p:nvPr/>
            </p:nvSpPr>
            <p:spPr>
              <a:xfrm>
                <a:off x="6318075" y="3717684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5</a:t>
                </a:r>
                <a:endParaRPr lang="en-US" dirty="0"/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98DD4B56-86F2-428A-A592-74C8563840F3}"/>
                </a:ext>
              </a:extLst>
            </p:cNvPr>
            <p:cNvGrpSpPr/>
            <p:nvPr/>
          </p:nvGrpSpPr>
          <p:grpSpPr>
            <a:xfrm>
              <a:off x="9125206" y="3711593"/>
              <a:ext cx="2726978" cy="3115390"/>
              <a:chOff x="9129546" y="165660"/>
              <a:chExt cx="2726978" cy="3115390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46046FE9-9627-4EE8-B25D-651EF01280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60" t="5963" r="6543" b="6690"/>
              <a:stretch/>
            </p:blipFill>
            <p:spPr>
              <a:xfrm>
                <a:off x="9129546" y="520917"/>
                <a:ext cx="2726978" cy="2760133"/>
              </a:xfrm>
              <a:prstGeom prst="rect">
                <a:avLst/>
              </a:prstGeom>
            </p:spPr>
          </p:pic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26ED06BF-A85F-434E-BB48-5CCBC306B944}"/>
                  </a:ext>
                </a:extLst>
              </p:cNvPr>
              <p:cNvSpPr txBox="1"/>
              <p:nvPr/>
            </p:nvSpPr>
            <p:spPr>
              <a:xfrm>
                <a:off x="9693872" y="165660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7</a:t>
                </a:r>
                <a:endParaRPr 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176929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>
            <a:extLst>
              <a:ext uri="{FF2B5EF4-FFF2-40B4-BE49-F238E27FC236}">
                <a16:creationId xmlns:a16="http://schemas.microsoft.com/office/drawing/2014/main" id="{FC20CA23-9622-4547-9564-DAC6692B28C1}"/>
              </a:ext>
            </a:extLst>
          </p:cNvPr>
          <p:cNvGrpSpPr/>
          <p:nvPr/>
        </p:nvGrpSpPr>
        <p:grpSpPr>
          <a:xfrm>
            <a:off x="2622266" y="88086"/>
            <a:ext cx="2486445" cy="2626255"/>
            <a:chOff x="6180664" y="179401"/>
            <a:chExt cx="2486445" cy="2626255"/>
          </a:xfrm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C169DA46-51D9-4750-894F-C0A473B6E3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71" t="7507" r="6783" b="7507"/>
            <a:stretch/>
          </p:blipFill>
          <p:spPr>
            <a:xfrm flipH="1">
              <a:off x="6180664" y="364067"/>
              <a:ext cx="2486445" cy="2441589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56790CB-4F2B-45D9-98CE-D13AB791FBA6}"/>
                </a:ext>
              </a:extLst>
            </p:cNvPr>
            <p:cNvSpPr txBox="1"/>
            <p:nvPr/>
          </p:nvSpPr>
          <p:spPr>
            <a:xfrm>
              <a:off x="7061680" y="179401"/>
              <a:ext cx="11269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34</a:t>
              </a:r>
            </a:p>
          </p:txBody>
        </p:sp>
      </p:grpSp>
      <p:grpSp>
        <p:nvGrpSpPr>
          <p:cNvPr id="38" name="Group 37">
            <a:extLst>
              <a:ext uri="{FF2B5EF4-FFF2-40B4-BE49-F238E27FC236}">
                <a16:creationId xmlns:a16="http://schemas.microsoft.com/office/drawing/2014/main" id="{815E982F-C4A0-496D-BAF0-5F8901460552}"/>
              </a:ext>
            </a:extLst>
          </p:cNvPr>
          <p:cNvGrpSpPr/>
          <p:nvPr/>
        </p:nvGrpSpPr>
        <p:grpSpPr>
          <a:xfrm>
            <a:off x="211245" y="88086"/>
            <a:ext cx="2428322" cy="2773397"/>
            <a:chOff x="395661" y="201123"/>
            <a:chExt cx="2428322" cy="2773397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E47E9C6-74E2-4AA2-A93E-9EF7D057846D}"/>
                </a:ext>
              </a:extLst>
            </p:cNvPr>
            <p:cNvSpPr txBox="1"/>
            <p:nvPr/>
          </p:nvSpPr>
          <p:spPr>
            <a:xfrm>
              <a:off x="1153846" y="201123"/>
              <a:ext cx="11269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28</a:t>
              </a:r>
            </a:p>
          </p:txBody>
        </p:sp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9ECBE87E-EC4F-474E-A5D5-3CE36F4A66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34" t="6296" r="5544" b="5308"/>
            <a:stretch/>
          </p:blipFill>
          <p:spPr>
            <a:xfrm>
              <a:off x="395661" y="519187"/>
              <a:ext cx="2428322" cy="2455333"/>
            </a:xfrm>
            <a:prstGeom prst="rect">
              <a:avLst/>
            </a:prstGeom>
          </p:spPr>
        </p:pic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96DFA670-9280-4B57-B0B9-2555C0BCAFBF}"/>
              </a:ext>
            </a:extLst>
          </p:cNvPr>
          <p:cNvGrpSpPr/>
          <p:nvPr/>
        </p:nvGrpSpPr>
        <p:grpSpPr>
          <a:xfrm>
            <a:off x="5972426" y="104769"/>
            <a:ext cx="2047619" cy="2402942"/>
            <a:chOff x="9399313" y="145525"/>
            <a:chExt cx="2047619" cy="2402942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42F9F325-42C1-458C-BCFC-4A0276ED51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93" t="6297" r="6416" b="7507"/>
            <a:stretch/>
          </p:blipFill>
          <p:spPr>
            <a:xfrm>
              <a:off x="9399313" y="514857"/>
              <a:ext cx="2047619" cy="2033610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9103AF8A-1BDF-42F1-BCA4-A1846612C043}"/>
                </a:ext>
              </a:extLst>
            </p:cNvPr>
            <p:cNvSpPr txBox="1"/>
            <p:nvPr/>
          </p:nvSpPr>
          <p:spPr>
            <a:xfrm>
              <a:off x="9911179" y="145525"/>
              <a:ext cx="11269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41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3123C6BD-16A9-4A2D-8C2F-C5F40FB7620B}"/>
              </a:ext>
            </a:extLst>
          </p:cNvPr>
          <p:cNvGrpSpPr/>
          <p:nvPr/>
        </p:nvGrpSpPr>
        <p:grpSpPr>
          <a:xfrm>
            <a:off x="9135413" y="36817"/>
            <a:ext cx="2455428" cy="2824666"/>
            <a:chOff x="3293438" y="3244334"/>
            <a:chExt cx="2455428" cy="2824666"/>
          </a:xfrm>
        </p:grpSpPr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E71AEB94-463F-4752-9796-C0FA043C78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34" t="6543" r="6050" b="6543"/>
            <a:stretch/>
          </p:blipFill>
          <p:spPr>
            <a:xfrm>
              <a:off x="3293438" y="3613666"/>
              <a:ext cx="2455428" cy="2455334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C2A89BE8-E45E-44DE-8F1C-61D3310DDBD4}"/>
                </a:ext>
              </a:extLst>
            </p:cNvPr>
            <p:cNvSpPr txBox="1"/>
            <p:nvPr/>
          </p:nvSpPr>
          <p:spPr>
            <a:xfrm>
              <a:off x="4130823" y="3244334"/>
              <a:ext cx="11269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44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57B514DC-09CC-42A7-B5DF-A4F47A869A94}"/>
              </a:ext>
            </a:extLst>
          </p:cNvPr>
          <p:cNvGrpSpPr/>
          <p:nvPr/>
        </p:nvGrpSpPr>
        <p:grpSpPr>
          <a:xfrm>
            <a:off x="92305" y="3429000"/>
            <a:ext cx="2739661" cy="3164480"/>
            <a:chOff x="6096000" y="3077055"/>
            <a:chExt cx="2739661" cy="3164480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057CAA52-7284-4EEE-8335-E177677322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34" t="6543" r="6666" b="6295"/>
            <a:stretch/>
          </p:blipFill>
          <p:spPr>
            <a:xfrm>
              <a:off x="6096000" y="3474545"/>
              <a:ext cx="2739661" cy="2766990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993C308-E5CC-4E74-8EB1-ACC17A6D0BF5}"/>
                </a:ext>
              </a:extLst>
            </p:cNvPr>
            <p:cNvSpPr txBox="1"/>
            <p:nvPr/>
          </p:nvSpPr>
          <p:spPr>
            <a:xfrm>
              <a:off x="6770520" y="3077055"/>
              <a:ext cx="11269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49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B1C3E9AE-A941-4B2A-ADA4-E6357C186DBD}"/>
              </a:ext>
            </a:extLst>
          </p:cNvPr>
          <p:cNvGrpSpPr/>
          <p:nvPr/>
        </p:nvGrpSpPr>
        <p:grpSpPr>
          <a:xfrm>
            <a:off x="3479835" y="3487176"/>
            <a:ext cx="2735832" cy="2766991"/>
            <a:chOff x="9208370" y="3261721"/>
            <a:chExt cx="2735832" cy="2766991"/>
          </a:xfrm>
        </p:grpSpPr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6BBC8E95-842A-41BD-91D3-E5C8BC62FE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34" t="6296" r="6543" b="6296"/>
            <a:stretch/>
          </p:blipFill>
          <p:spPr>
            <a:xfrm>
              <a:off x="9208370" y="3261721"/>
              <a:ext cx="2735832" cy="2766991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E26EAD3-A6D2-4B27-A044-BBCD7E2BE398}"/>
                </a:ext>
              </a:extLst>
            </p:cNvPr>
            <p:cNvSpPr txBox="1"/>
            <p:nvPr/>
          </p:nvSpPr>
          <p:spPr>
            <a:xfrm>
              <a:off x="10244546" y="3261721"/>
              <a:ext cx="11269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52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40FA9C05-EB7D-4265-AB19-71C95459C369}"/>
              </a:ext>
            </a:extLst>
          </p:cNvPr>
          <p:cNvGrpSpPr/>
          <p:nvPr/>
        </p:nvGrpSpPr>
        <p:grpSpPr>
          <a:xfrm>
            <a:off x="6799165" y="3487176"/>
            <a:ext cx="2121099" cy="2460599"/>
            <a:chOff x="655967" y="265668"/>
            <a:chExt cx="2121099" cy="2460599"/>
          </a:xfrm>
        </p:grpSpPr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id="{B49162F1-BEA4-4F39-AAB5-9418219BA6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15" t="6915" r="5308" b="6543"/>
            <a:stretch/>
          </p:blipFill>
          <p:spPr>
            <a:xfrm>
              <a:off x="655967" y="635000"/>
              <a:ext cx="2121099" cy="2091267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1855C1B-AF29-4862-AC08-F8C7B4D53553}"/>
                </a:ext>
              </a:extLst>
            </p:cNvPr>
            <p:cNvSpPr txBox="1"/>
            <p:nvPr/>
          </p:nvSpPr>
          <p:spPr>
            <a:xfrm>
              <a:off x="735691" y="265668"/>
              <a:ext cx="11269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55</a:t>
              </a:r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F8579BFE-7D33-4D57-A2DE-47DD81B82B70}"/>
              </a:ext>
            </a:extLst>
          </p:cNvPr>
          <p:cNvGrpSpPr/>
          <p:nvPr/>
        </p:nvGrpSpPr>
        <p:grpSpPr>
          <a:xfrm>
            <a:off x="9630907" y="3399603"/>
            <a:ext cx="2175932" cy="2465150"/>
            <a:chOff x="304799" y="-157675"/>
            <a:chExt cx="2175932" cy="2465150"/>
          </a:xfrm>
        </p:grpSpPr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5ED33248-88B1-43F6-8469-4AF42851EB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66" t="6666" r="6790" b="6913"/>
            <a:stretch/>
          </p:blipFill>
          <p:spPr>
            <a:xfrm>
              <a:off x="304799" y="134647"/>
              <a:ext cx="2175932" cy="2172828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0A08CA9-8920-4FD3-BB5F-8C5FEA141E67}"/>
                </a:ext>
              </a:extLst>
            </p:cNvPr>
            <p:cNvSpPr txBox="1"/>
            <p:nvPr/>
          </p:nvSpPr>
          <p:spPr>
            <a:xfrm>
              <a:off x="829278" y="-157675"/>
              <a:ext cx="11269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6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009760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oup 27">
            <a:extLst>
              <a:ext uri="{FF2B5EF4-FFF2-40B4-BE49-F238E27FC236}">
                <a16:creationId xmlns:a16="http://schemas.microsoft.com/office/drawing/2014/main" id="{559F0521-6416-466C-9C84-2B8749F78D72}"/>
              </a:ext>
            </a:extLst>
          </p:cNvPr>
          <p:cNvGrpSpPr/>
          <p:nvPr/>
        </p:nvGrpSpPr>
        <p:grpSpPr>
          <a:xfrm>
            <a:off x="138091" y="100442"/>
            <a:ext cx="2842826" cy="2810789"/>
            <a:chOff x="2939909" y="42468"/>
            <a:chExt cx="2842826" cy="2810789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43378075-B2E3-426C-965C-095297FD1B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44" t="6915" r="6296" b="6913"/>
            <a:stretch/>
          </p:blipFill>
          <p:spPr>
            <a:xfrm>
              <a:off x="3110859" y="211657"/>
              <a:ext cx="2671876" cy="2641600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DB2BE4E-EA4C-4B40-BE1B-4D0275549CE7}"/>
                </a:ext>
              </a:extLst>
            </p:cNvPr>
            <p:cNvSpPr txBox="1"/>
            <p:nvPr/>
          </p:nvSpPr>
          <p:spPr>
            <a:xfrm>
              <a:off x="2939909" y="42468"/>
              <a:ext cx="11269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96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9DABC211-8FD2-4C37-9D46-DC2D7122DABA}"/>
              </a:ext>
            </a:extLst>
          </p:cNvPr>
          <p:cNvGrpSpPr/>
          <p:nvPr/>
        </p:nvGrpSpPr>
        <p:grpSpPr>
          <a:xfrm>
            <a:off x="3467824" y="183675"/>
            <a:ext cx="2375981" cy="2690799"/>
            <a:chOff x="5989086" y="26991"/>
            <a:chExt cx="2375981" cy="2690799"/>
          </a:xfrm>
        </p:grpSpPr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D877309F-1AEA-49E2-9379-CE9424DA98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72" t="6666" r="6543" b="6543"/>
            <a:stretch/>
          </p:blipFill>
          <p:spPr>
            <a:xfrm>
              <a:off x="5989086" y="347123"/>
              <a:ext cx="2375981" cy="2370667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F483B7C-A61F-45B3-991B-B60431B0A75B}"/>
                </a:ext>
              </a:extLst>
            </p:cNvPr>
            <p:cNvSpPr txBox="1"/>
            <p:nvPr/>
          </p:nvSpPr>
          <p:spPr>
            <a:xfrm>
              <a:off x="6133188" y="26991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102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2F702D6D-A310-44F7-A7CE-5BD8A47F8FB1}"/>
              </a:ext>
            </a:extLst>
          </p:cNvPr>
          <p:cNvGrpSpPr/>
          <p:nvPr/>
        </p:nvGrpSpPr>
        <p:grpSpPr>
          <a:xfrm>
            <a:off x="6153624" y="183675"/>
            <a:ext cx="2538645" cy="2570810"/>
            <a:chOff x="8715520" y="80809"/>
            <a:chExt cx="2538645" cy="2570810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15746CFD-897C-4A48-ADF9-4CD3E769FA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33" t="6563" r="6667" b="6667"/>
            <a:stretch/>
          </p:blipFill>
          <p:spPr>
            <a:xfrm>
              <a:off x="8715520" y="137018"/>
              <a:ext cx="2538645" cy="2514601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7410E73-0D9F-4E17-9D66-E47DEB779C61}"/>
                </a:ext>
              </a:extLst>
            </p:cNvPr>
            <p:cNvSpPr txBox="1"/>
            <p:nvPr/>
          </p:nvSpPr>
          <p:spPr>
            <a:xfrm>
              <a:off x="9587588" y="80809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110</a:t>
              </a:r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396EC609-144A-4E59-8E07-E603873852C4}"/>
              </a:ext>
            </a:extLst>
          </p:cNvPr>
          <p:cNvGrpSpPr/>
          <p:nvPr/>
        </p:nvGrpSpPr>
        <p:grpSpPr>
          <a:xfrm>
            <a:off x="9631568" y="122943"/>
            <a:ext cx="2251391" cy="2631542"/>
            <a:chOff x="229341" y="3134257"/>
            <a:chExt cx="2251391" cy="2631542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B3940C66-7043-4031-802D-06F1E5529D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72" t="6563" r="6296" b="7160"/>
            <a:stretch/>
          </p:blipFill>
          <p:spPr>
            <a:xfrm>
              <a:off x="229341" y="3539077"/>
              <a:ext cx="2251391" cy="2226722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ACE18D7-C97E-4194-9522-85BA7C87CCBC}"/>
                </a:ext>
              </a:extLst>
            </p:cNvPr>
            <p:cNvSpPr txBox="1"/>
            <p:nvPr/>
          </p:nvSpPr>
          <p:spPr>
            <a:xfrm>
              <a:off x="492125" y="3134257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112</a:t>
              </a: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278F049A-8955-419E-B03A-6074C13E92D7}"/>
              </a:ext>
            </a:extLst>
          </p:cNvPr>
          <p:cNvGrpSpPr/>
          <p:nvPr/>
        </p:nvGrpSpPr>
        <p:grpSpPr>
          <a:xfrm>
            <a:off x="63246" y="3687036"/>
            <a:ext cx="2651489" cy="2794655"/>
            <a:chOff x="2763596" y="3134257"/>
            <a:chExt cx="2651489" cy="2794655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DC8581B4-A61D-476F-BD2A-230182138A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23" t="6521" r="5633" b="6420"/>
            <a:stretch/>
          </p:blipFill>
          <p:spPr>
            <a:xfrm>
              <a:off x="2763596" y="3318923"/>
              <a:ext cx="2651489" cy="2609989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E4FA87E-D9C5-419A-84C3-BDCD58AB01D1}"/>
                </a:ext>
              </a:extLst>
            </p:cNvPr>
            <p:cNvSpPr txBox="1"/>
            <p:nvPr/>
          </p:nvSpPr>
          <p:spPr>
            <a:xfrm>
              <a:off x="3777192" y="3134257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117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3F364AFB-D1B4-4E86-9EAC-1FF2BE2806F4}"/>
              </a:ext>
            </a:extLst>
          </p:cNvPr>
          <p:cNvGrpSpPr/>
          <p:nvPr/>
        </p:nvGrpSpPr>
        <p:grpSpPr>
          <a:xfrm>
            <a:off x="3102195" y="3724461"/>
            <a:ext cx="2381299" cy="2684364"/>
            <a:chOff x="5871609" y="3299969"/>
            <a:chExt cx="2381299" cy="2684364"/>
          </a:xfrm>
        </p:grpSpPr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3A18D8B7-0023-41F7-A93F-0D484758E0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90" t="6307" r="5433" b="6307"/>
            <a:stretch/>
          </p:blipFill>
          <p:spPr>
            <a:xfrm>
              <a:off x="5871609" y="3613666"/>
              <a:ext cx="2381299" cy="2370667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896C992-F482-4DFA-BE4A-1AAE5C5B6D21}"/>
                </a:ext>
              </a:extLst>
            </p:cNvPr>
            <p:cNvSpPr txBox="1"/>
            <p:nvPr/>
          </p:nvSpPr>
          <p:spPr>
            <a:xfrm>
              <a:off x="6759200" y="3299969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131</a:t>
              </a:r>
            </a:p>
          </p:txBody>
        </p:sp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0F46138A-5A5B-4C60-BA53-D95992E539B4}"/>
              </a:ext>
            </a:extLst>
          </p:cNvPr>
          <p:cNvGrpSpPr/>
          <p:nvPr/>
        </p:nvGrpSpPr>
        <p:grpSpPr>
          <a:xfrm>
            <a:off x="6096000" y="3687036"/>
            <a:ext cx="2619590" cy="2998060"/>
            <a:chOff x="9005143" y="3168146"/>
            <a:chExt cx="2619590" cy="2998060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F8FDB0B3-987C-4FE3-B500-4A31E7469E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90" t="7025" r="6790" b="6307"/>
            <a:stretch/>
          </p:blipFill>
          <p:spPr>
            <a:xfrm>
              <a:off x="9005143" y="3539077"/>
              <a:ext cx="2619590" cy="2627129"/>
            </a:xfrm>
            <a:prstGeom prst="rect">
              <a:avLst/>
            </a:prstGeom>
          </p:spPr>
        </p:pic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BAE91955-21F2-4632-8A2F-BEE66EDD6947}"/>
                </a:ext>
              </a:extLst>
            </p:cNvPr>
            <p:cNvSpPr txBox="1"/>
            <p:nvPr/>
          </p:nvSpPr>
          <p:spPr>
            <a:xfrm>
              <a:off x="9636170" y="3168146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139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2C4240A5-14FF-418B-96CD-CA8BA4421A8A}"/>
              </a:ext>
            </a:extLst>
          </p:cNvPr>
          <p:cNvGrpSpPr/>
          <p:nvPr/>
        </p:nvGrpSpPr>
        <p:grpSpPr>
          <a:xfrm>
            <a:off x="9251148" y="3595503"/>
            <a:ext cx="2734734" cy="2734734"/>
            <a:chOff x="59267" y="93133"/>
            <a:chExt cx="2734734" cy="2734734"/>
          </a:xfrm>
        </p:grpSpPr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F3CC8E17-D4B5-4AB3-81DD-7C94F5F452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15" t="6915" r="6913" b="6913"/>
            <a:stretch/>
          </p:blipFill>
          <p:spPr>
            <a:xfrm>
              <a:off x="59267" y="93133"/>
              <a:ext cx="2734734" cy="2734734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A9378B2-669D-4771-B36F-BB8804B561E2}"/>
                </a:ext>
              </a:extLst>
            </p:cNvPr>
            <p:cNvSpPr txBox="1"/>
            <p:nvPr/>
          </p:nvSpPr>
          <p:spPr>
            <a:xfrm>
              <a:off x="943384" y="184666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14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029970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F6907579-CD31-4DEB-955D-836A9C63773A}"/>
              </a:ext>
            </a:extLst>
          </p:cNvPr>
          <p:cNvGrpSpPr/>
          <p:nvPr/>
        </p:nvGrpSpPr>
        <p:grpSpPr>
          <a:xfrm>
            <a:off x="76257" y="0"/>
            <a:ext cx="2517607" cy="2871485"/>
            <a:chOff x="3061926" y="-43618"/>
            <a:chExt cx="2517607" cy="2871485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230E87DE-B6F7-4E1B-8C0C-C992EDEC7C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96" t="6543" r="6172" b="6914"/>
            <a:stretch/>
          </p:blipFill>
          <p:spPr>
            <a:xfrm>
              <a:off x="3061926" y="338667"/>
              <a:ext cx="2517607" cy="24892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8439D97-2FE2-4937-95CA-231C3EDEF354}"/>
                </a:ext>
              </a:extLst>
            </p:cNvPr>
            <p:cNvSpPr txBox="1"/>
            <p:nvPr/>
          </p:nvSpPr>
          <p:spPr>
            <a:xfrm>
              <a:off x="4025722" y="-43618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150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2D63284D-19C5-443B-A509-635527BBE8F4}"/>
              </a:ext>
            </a:extLst>
          </p:cNvPr>
          <p:cNvGrpSpPr/>
          <p:nvPr/>
        </p:nvGrpSpPr>
        <p:grpSpPr>
          <a:xfrm>
            <a:off x="2593864" y="5998"/>
            <a:ext cx="3007296" cy="3302000"/>
            <a:chOff x="5661191" y="0"/>
            <a:chExt cx="3007296" cy="3302000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2B0FFBDD-4AC1-4DDB-AEE0-9C3539060C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58" t="7037" r="6790" b="6790"/>
            <a:stretch/>
          </p:blipFill>
          <p:spPr>
            <a:xfrm>
              <a:off x="5661191" y="338667"/>
              <a:ext cx="3007296" cy="2963333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A486B521-4FDB-4906-B033-8858B1940F84}"/>
                </a:ext>
              </a:extLst>
            </p:cNvPr>
            <p:cNvSpPr txBox="1"/>
            <p:nvPr/>
          </p:nvSpPr>
          <p:spPr>
            <a:xfrm>
              <a:off x="7164839" y="0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152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03EE9E03-9F75-4CB8-90F4-89D43DEBA833}"/>
              </a:ext>
            </a:extLst>
          </p:cNvPr>
          <p:cNvGrpSpPr/>
          <p:nvPr/>
        </p:nvGrpSpPr>
        <p:grpSpPr>
          <a:xfrm>
            <a:off x="6090047" y="50494"/>
            <a:ext cx="2803855" cy="3152781"/>
            <a:chOff x="72834" y="3524238"/>
            <a:chExt cx="2803855" cy="3152781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F2FE4D0F-F4A6-4AE2-8852-E58A02720D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99" t="6343" r="6914" b="6791"/>
            <a:stretch/>
          </p:blipFill>
          <p:spPr>
            <a:xfrm>
              <a:off x="72834" y="3857619"/>
              <a:ext cx="2803855" cy="2819400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77DD3F5-29B2-4181-87B3-B7D8188358FE}"/>
                </a:ext>
              </a:extLst>
            </p:cNvPr>
            <p:cNvSpPr txBox="1"/>
            <p:nvPr/>
          </p:nvSpPr>
          <p:spPr>
            <a:xfrm>
              <a:off x="713324" y="3524238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218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95EE2361-3B61-41BF-9AB2-A3D174956C23}"/>
              </a:ext>
            </a:extLst>
          </p:cNvPr>
          <p:cNvGrpSpPr/>
          <p:nvPr/>
        </p:nvGrpSpPr>
        <p:grpSpPr>
          <a:xfrm>
            <a:off x="9103909" y="159999"/>
            <a:ext cx="2693642" cy="2960694"/>
            <a:chOff x="11983342" y="301563"/>
            <a:chExt cx="2693642" cy="2960694"/>
          </a:xfrm>
        </p:grpSpPr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E5DE9D6D-327E-44C3-A063-0F164793D2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99" t="6343" r="6790" b="6914"/>
            <a:stretch/>
          </p:blipFill>
          <p:spPr>
            <a:xfrm>
              <a:off x="11983342" y="561390"/>
              <a:ext cx="2693642" cy="2700867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FF27F05-52B6-46E9-8EA0-962B31F8FDDF}"/>
                </a:ext>
              </a:extLst>
            </p:cNvPr>
            <p:cNvSpPr txBox="1"/>
            <p:nvPr/>
          </p:nvSpPr>
          <p:spPr>
            <a:xfrm>
              <a:off x="12625326" y="301563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226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C25F7D60-F073-4EBA-9BF2-A168541B10D0}"/>
              </a:ext>
            </a:extLst>
          </p:cNvPr>
          <p:cNvGrpSpPr/>
          <p:nvPr/>
        </p:nvGrpSpPr>
        <p:grpSpPr>
          <a:xfrm>
            <a:off x="76257" y="3517094"/>
            <a:ext cx="3300811" cy="2848747"/>
            <a:chOff x="5794367" y="3828272"/>
            <a:chExt cx="3300811" cy="2848747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BD027CB-F747-4638-B880-F6D2ED29EB59}"/>
                </a:ext>
              </a:extLst>
            </p:cNvPr>
            <p:cNvSpPr txBox="1"/>
            <p:nvPr/>
          </p:nvSpPr>
          <p:spPr>
            <a:xfrm>
              <a:off x="6200777" y="3828272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255</a:t>
              </a:r>
            </a:p>
          </p:txBody>
        </p:sp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626BB2C5-FE73-4AD4-929C-B3ED19707C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9239"/>
            <a:stretch/>
          </p:blipFill>
          <p:spPr>
            <a:xfrm>
              <a:off x="5794367" y="4205292"/>
              <a:ext cx="3300811" cy="2471727"/>
            </a:xfrm>
            <a:prstGeom prst="rect">
              <a:avLst/>
            </a:prstGeom>
          </p:spPr>
        </p:pic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AE41BB7A-8114-4EF3-ADC3-7005D1CCF981}"/>
              </a:ext>
            </a:extLst>
          </p:cNvPr>
          <p:cNvGrpSpPr/>
          <p:nvPr/>
        </p:nvGrpSpPr>
        <p:grpSpPr>
          <a:xfrm>
            <a:off x="3284581" y="3615502"/>
            <a:ext cx="2880411" cy="2931715"/>
            <a:chOff x="3183395" y="152400"/>
            <a:chExt cx="2971872" cy="3081867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AB8ECDD0-B1A7-453A-A243-9429B793DE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19" t="6048" r="6543" b="6420"/>
            <a:stretch/>
          </p:blipFill>
          <p:spPr>
            <a:xfrm>
              <a:off x="3183395" y="245534"/>
              <a:ext cx="2971872" cy="2988733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27A95326-0751-4BFF-8365-273C24186426}"/>
                </a:ext>
              </a:extLst>
            </p:cNvPr>
            <p:cNvSpPr txBox="1"/>
            <p:nvPr/>
          </p:nvSpPr>
          <p:spPr>
            <a:xfrm>
              <a:off x="4379390" y="152400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278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0ABD039D-68FA-4C10-A68D-699BAE87ECAE}"/>
              </a:ext>
            </a:extLst>
          </p:cNvPr>
          <p:cNvGrpSpPr/>
          <p:nvPr/>
        </p:nvGrpSpPr>
        <p:grpSpPr>
          <a:xfrm>
            <a:off x="6749719" y="3380520"/>
            <a:ext cx="2623597" cy="2935005"/>
            <a:chOff x="9095178" y="3584328"/>
            <a:chExt cx="2623597" cy="2935005"/>
          </a:xfrm>
        </p:grpSpPr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254DCE09-AC71-427F-AFFC-74FA597700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80" t="6744" r="6267" b="7407"/>
            <a:stretch/>
          </p:blipFill>
          <p:spPr>
            <a:xfrm>
              <a:off x="9095178" y="3920066"/>
              <a:ext cx="2623597" cy="2599267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BB6E35A-4ABF-44D0-B485-D932761CB295}"/>
                </a:ext>
              </a:extLst>
            </p:cNvPr>
            <p:cNvSpPr txBox="1"/>
            <p:nvPr/>
          </p:nvSpPr>
          <p:spPr>
            <a:xfrm>
              <a:off x="10026052" y="3584328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280</a:t>
              </a:r>
            </a:p>
          </p:txBody>
        </p: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170BC821-61CE-4B07-8A27-DB93C65422ED}"/>
              </a:ext>
            </a:extLst>
          </p:cNvPr>
          <p:cNvGrpSpPr/>
          <p:nvPr/>
        </p:nvGrpSpPr>
        <p:grpSpPr>
          <a:xfrm>
            <a:off x="9644208" y="3409400"/>
            <a:ext cx="2384168" cy="2756931"/>
            <a:chOff x="9739143" y="3527480"/>
            <a:chExt cx="2384168" cy="2756931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4CAB49BF-5226-4591-9A1B-42CFA937DB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37" t="7284" r="7161" b="6790"/>
            <a:stretch/>
          </p:blipFill>
          <p:spPr>
            <a:xfrm>
              <a:off x="9739143" y="3896812"/>
              <a:ext cx="2384168" cy="2387599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04D3751D-2B43-4A69-9735-A7A743F20B5F}"/>
                </a:ext>
              </a:extLst>
            </p:cNvPr>
            <p:cNvSpPr txBox="1"/>
            <p:nvPr/>
          </p:nvSpPr>
          <p:spPr>
            <a:xfrm>
              <a:off x="9958165" y="3527480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29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464191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0A01CA5A-5765-4BAC-9538-68415FAAD640}"/>
              </a:ext>
            </a:extLst>
          </p:cNvPr>
          <p:cNvGrpSpPr/>
          <p:nvPr/>
        </p:nvGrpSpPr>
        <p:grpSpPr>
          <a:xfrm>
            <a:off x="192762" y="95374"/>
            <a:ext cx="2805158" cy="3146399"/>
            <a:chOff x="5750141" y="46199"/>
            <a:chExt cx="2805158" cy="3146399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1D69EB11-CF60-4530-AC5F-D59F1AEEFF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37" t="7284" r="6666" b="7284"/>
            <a:stretch/>
          </p:blipFill>
          <p:spPr>
            <a:xfrm>
              <a:off x="5750141" y="415531"/>
              <a:ext cx="2805158" cy="2777067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84EBDA5-B6CC-452F-8103-53CCB0942E4B}"/>
                </a:ext>
              </a:extLst>
            </p:cNvPr>
            <p:cNvSpPr txBox="1"/>
            <p:nvPr/>
          </p:nvSpPr>
          <p:spPr>
            <a:xfrm>
              <a:off x="6304054" y="46199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334</a:t>
              </a: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759241C6-455D-4386-8364-1A6622050A70}"/>
              </a:ext>
            </a:extLst>
          </p:cNvPr>
          <p:cNvGrpSpPr/>
          <p:nvPr/>
        </p:nvGrpSpPr>
        <p:grpSpPr>
          <a:xfrm>
            <a:off x="3639665" y="277478"/>
            <a:ext cx="2734765" cy="3151522"/>
            <a:chOff x="8874484" y="86634"/>
            <a:chExt cx="2734765" cy="3151522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D034A3A6-BB31-4BED-825D-268379431D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19" t="6059" r="7037" b="6059"/>
            <a:stretch/>
          </p:blipFill>
          <p:spPr>
            <a:xfrm>
              <a:off x="8874484" y="461089"/>
              <a:ext cx="2734765" cy="2777067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FFD4D27-CA71-49A5-956B-9F013549DC43}"/>
                </a:ext>
              </a:extLst>
            </p:cNvPr>
            <p:cNvSpPr txBox="1"/>
            <p:nvPr/>
          </p:nvSpPr>
          <p:spPr>
            <a:xfrm>
              <a:off x="9619868" y="86634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385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60169769-F4E4-44C2-82F6-069C5328BB27}"/>
              </a:ext>
            </a:extLst>
          </p:cNvPr>
          <p:cNvGrpSpPr/>
          <p:nvPr/>
        </p:nvGrpSpPr>
        <p:grpSpPr>
          <a:xfrm>
            <a:off x="7228247" y="222693"/>
            <a:ext cx="2341926" cy="3019080"/>
            <a:chOff x="213429" y="3373254"/>
            <a:chExt cx="2341926" cy="3019080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278A0477-DA87-4D59-8588-9C91F11ED2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96" t="6419" r="7160" b="6913"/>
            <a:stretch/>
          </p:blipFill>
          <p:spPr>
            <a:xfrm>
              <a:off x="213429" y="4047067"/>
              <a:ext cx="2341926" cy="2345267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E60CA83-96B7-4A78-B763-01B127F97773}"/>
                </a:ext>
              </a:extLst>
            </p:cNvPr>
            <p:cNvSpPr txBox="1"/>
            <p:nvPr/>
          </p:nvSpPr>
          <p:spPr>
            <a:xfrm>
              <a:off x="889394" y="3373254"/>
              <a:ext cx="12439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dirty="0"/>
                <a:t>Cluster 437</a:t>
              </a:r>
            </a:p>
          </p:txBody>
        </p:sp>
      </p:grpSp>
      <p:sp>
        <p:nvSpPr>
          <p:cNvPr id="4" name="Rectangle 3">
            <a:extLst>
              <a:ext uri="{FF2B5EF4-FFF2-40B4-BE49-F238E27FC236}">
                <a16:creationId xmlns:a16="http://schemas.microsoft.com/office/drawing/2014/main" id="{EE63321C-629F-41BC-90ED-EE5616CE6956}"/>
              </a:ext>
            </a:extLst>
          </p:cNvPr>
          <p:cNvSpPr/>
          <p:nvPr/>
        </p:nvSpPr>
        <p:spPr>
          <a:xfrm>
            <a:off x="2518962" y="3915298"/>
            <a:ext cx="622016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und Network for significant clusters.  </a:t>
            </a:r>
          </a:p>
        </p:txBody>
      </p:sp>
    </p:spTree>
    <p:extLst>
      <p:ext uri="{BB962C8B-B14F-4D97-AF65-F5344CB8AC3E}">
        <p14:creationId xmlns:p14="http://schemas.microsoft.com/office/powerpoint/2010/main" val="423525444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360E1DBC-8658-497F-8FF8-ED360B607614}"/>
              </a:ext>
            </a:extLst>
          </p:cNvPr>
          <p:cNvGrpSpPr/>
          <p:nvPr/>
        </p:nvGrpSpPr>
        <p:grpSpPr>
          <a:xfrm>
            <a:off x="-3821" y="563044"/>
            <a:ext cx="11724503" cy="5346631"/>
            <a:chOff x="-3821" y="563044"/>
            <a:chExt cx="11724503" cy="5346631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131658E1-3CA2-4EEF-91F4-FC463312C040}"/>
                </a:ext>
              </a:extLst>
            </p:cNvPr>
            <p:cNvGrpSpPr/>
            <p:nvPr/>
          </p:nvGrpSpPr>
          <p:grpSpPr>
            <a:xfrm>
              <a:off x="0" y="582750"/>
              <a:ext cx="2856718" cy="2465597"/>
              <a:chOff x="0" y="582750"/>
              <a:chExt cx="2856718" cy="2465597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715F7F7A-8402-408C-BDBC-3204B67BD02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91" t="11376" r="7573"/>
              <a:stretch/>
            </p:blipFill>
            <p:spPr>
              <a:xfrm>
                <a:off x="0" y="922866"/>
                <a:ext cx="2856718" cy="2125481"/>
              </a:xfrm>
              <a:prstGeom prst="rect">
                <a:avLst/>
              </a:prstGeom>
            </p:spPr>
          </p:pic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4DE12CA4-25B8-4FCB-8835-3FFB8B814FE7}"/>
                  </a:ext>
                </a:extLst>
              </p:cNvPr>
              <p:cNvSpPr txBox="1"/>
              <p:nvPr/>
            </p:nvSpPr>
            <p:spPr>
              <a:xfrm>
                <a:off x="972485" y="582750"/>
                <a:ext cx="104688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0</a:t>
                </a:r>
                <a:endParaRPr lang="en-US" dirty="0"/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56D45FC7-670C-42DC-8191-EFFDFDD498B4}"/>
                </a:ext>
              </a:extLst>
            </p:cNvPr>
            <p:cNvGrpSpPr/>
            <p:nvPr/>
          </p:nvGrpSpPr>
          <p:grpSpPr>
            <a:xfrm>
              <a:off x="2856718" y="574005"/>
              <a:ext cx="3312000" cy="2521960"/>
              <a:chOff x="2856718" y="574005"/>
              <a:chExt cx="3312000" cy="2521960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22737963-50C7-46E6-96C9-8744F56F1A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805"/>
              <a:stretch/>
            </p:blipFill>
            <p:spPr>
              <a:xfrm>
                <a:off x="2856718" y="880346"/>
                <a:ext cx="3312000" cy="2215619"/>
              </a:xfrm>
              <a:prstGeom prst="rect">
                <a:avLst/>
              </a:prstGeom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D5AE00D4-FAEB-4223-9E90-3F12FF9C9782}"/>
                  </a:ext>
                </a:extLst>
              </p:cNvPr>
              <p:cNvSpPr txBox="1"/>
              <p:nvPr/>
            </p:nvSpPr>
            <p:spPr>
              <a:xfrm>
                <a:off x="4063409" y="574005"/>
                <a:ext cx="1075303" cy="3474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1</a:t>
                </a:r>
                <a:endParaRPr lang="en-US" dirty="0"/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1AB1D7A8-FCD9-4B81-A44E-7D451D15C8E2}"/>
                </a:ext>
              </a:extLst>
            </p:cNvPr>
            <p:cNvGrpSpPr/>
            <p:nvPr/>
          </p:nvGrpSpPr>
          <p:grpSpPr>
            <a:xfrm>
              <a:off x="5976064" y="563044"/>
              <a:ext cx="2844000" cy="2511690"/>
              <a:chOff x="5976064" y="563044"/>
              <a:chExt cx="2844000" cy="2511690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F23F791D-E9ED-45B9-A988-3A0299CF1B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24" t="11666" r="7176"/>
              <a:stretch/>
            </p:blipFill>
            <p:spPr>
              <a:xfrm>
                <a:off x="5976064" y="921417"/>
                <a:ext cx="2844000" cy="2153317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42FB3CA-FFCF-41E6-A576-2EAA4F9EBFF9}"/>
                  </a:ext>
                </a:extLst>
              </p:cNvPr>
              <p:cNvSpPr txBox="1"/>
              <p:nvPr/>
            </p:nvSpPr>
            <p:spPr>
              <a:xfrm>
                <a:off x="7053290" y="563044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2</a:t>
                </a:r>
                <a:endParaRPr lang="en-US" dirty="0"/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9EF530A1-1496-49A5-B6FB-9B6BC068BBBE}"/>
                </a:ext>
              </a:extLst>
            </p:cNvPr>
            <p:cNvGrpSpPr/>
            <p:nvPr/>
          </p:nvGrpSpPr>
          <p:grpSpPr>
            <a:xfrm>
              <a:off x="-3821" y="3418597"/>
              <a:ext cx="2880000" cy="2491078"/>
              <a:chOff x="-3821" y="3418597"/>
              <a:chExt cx="2880000" cy="2491078"/>
            </a:xfrm>
          </p:grpSpPr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AAF6A8D7-6B52-4207-B0DE-8B5FB04339B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4468"/>
              <a:stretch/>
            </p:blipFill>
            <p:spPr>
              <a:xfrm>
                <a:off x="-3821" y="3689955"/>
                <a:ext cx="2880000" cy="2219720"/>
              </a:xfrm>
              <a:prstGeom prst="rect">
                <a:avLst/>
              </a:prstGeom>
            </p:spPr>
          </p:pic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F0F5A64F-03F6-4010-AAEF-77A5F0D847D3}"/>
                  </a:ext>
                </a:extLst>
              </p:cNvPr>
              <p:cNvSpPr txBox="1"/>
              <p:nvPr/>
            </p:nvSpPr>
            <p:spPr>
              <a:xfrm>
                <a:off x="972485" y="3418597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1</a:t>
                </a:r>
                <a:endParaRPr lang="en-US" dirty="0"/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9EE397E5-D733-43F1-BD66-71221FBB6CC3}"/>
                </a:ext>
              </a:extLst>
            </p:cNvPr>
            <p:cNvGrpSpPr/>
            <p:nvPr/>
          </p:nvGrpSpPr>
          <p:grpSpPr>
            <a:xfrm>
              <a:off x="3037798" y="3429000"/>
              <a:ext cx="2880000" cy="2432534"/>
              <a:chOff x="2759795" y="3429000"/>
              <a:chExt cx="2880000" cy="2432534"/>
            </a:xfrm>
          </p:grpSpPr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C09A4273-8C06-4A40-8E1F-2EBE47C803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3616" r="1358"/>
              <a:stretch/>
            </p:blipFill>
            <p:spPr>
              <a:xfrm>
                <a:off x="2759795" y="3694534"/>
                <a:ext cx="2880000" cy="2167000"/>
              </a:xfrm>
              <a:prstGeom prst="rect">
                <a:avLst/>
              </a:prstGeom>
            </p:spPr>
          </p:pic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8B7E50D6-8BB9-47B0-B03B-E4554D86323B}"/>
                  </a:ext>
                </a:extLst>
              </p:cNvPr>
              <p:cNvSpPr txBox="1"/>
              <p:nvPr/>
            </p:nvSpPr>
            <p:spPr>
              <a:xfrm>
                <a:off x="3772727" y="3429000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3</a:t>
                </a:r>
                <a:endParaRPr lang="en-US" dirty="0"/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E6EB2CD2-3CB2-4D9A-99F3-B334CEB2A2AC}"/>
                </a:ext>
              </a:extLst>
            </p:cNvPr>
            <p:cNvGrpSpPr/>
            <p:nvPr/>
          </p:nvGrpSpPr>
          <p:grpSpPr>
            <a:xfrm>
              <a:off x="5976064" y="3454338"/>
              <a:ext cx="2880000" cy="2455337"/>
              <a:chOff x="5544707" y="3454338"/>
              <a:chExt cx="2880000" cy="2455337"/>
            </a:xfrm>
          </p:grpSpPr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DF0B56F7-E8BB-4FB1-8ABE-68EB011E9C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4796" r="1710"/>
              <a:stretch/>
            </p:blipFill>
            <p:spPr>
              <a:xfrm>
                <a:off x="5544707" y="3743555"/>
                <a:ext cx="2880000" cy="2166120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50534D74-6E13-402E-ACD7-DB3964DBB01C}"/>
                  </a:ext>
                </a:extLst>
              </p:cNvPr>
              <p:cNvSpPr txBox="1"/>
              <p:nvPr/>
            </p:nvSpPr>
            <p:spPr>
              <a:xfrm>
                <a:off x="6536343" y="3454338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5</a:t>
                </a:r>
                <a:endParaRPr lang="en-US" dirty="0"/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49C78C7B-86FB-4BA4-AE41-1D2F32A0D339}"/>
                </a:ext>
              </a:extLst>
            </p:cNvPr>
            <p:cNvGrpSpPr/>
            <p:nvPr/>
          </p:nvGrpSpPr>
          <p:grpSpPr>
            <a:xfrm>
              <a:off x="8840682" y="3505289"/>
              <a:ext cx="2880000" cy="2404386"/>
              <a:chOff x="8424707" y="3505289"/>
              <a:chExt cx="2880000" cy="2404386"/>
            </a:xfrm>
          </p:grpSpPr>
          <p:pic>
            <p:nvPicPr>
              <p:cNvPr id="34" name="Picture 33">
                <a:extLst>
                  <a:ext uri="{FF2B5EF4-FFF2-40B4-BE49-F238E27FC236}">
                    <a16:creationId xmlns:a16="http://schemas.microsoft.com/office/drawing/2014/main" id="{69F0E7C2-E21D-4422-A63C-CAF2C2EE57A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t="3789"/>
              <a:stretch/>
            </p:blipFill>
            <p:spPr>
              <a:xfrm>
                <a:off x="8424707" y="3798755"/>
                <a:ext cx="2880000" cy="2110920"/>
              </a:xfrm>
              <a:prstGeom prst="rect">
                <a:avLst/>
              </a:prstGeom>
            </p:spPr>
          </p:pic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98631E75-14E6-4C83-92EE-72ABC44815E3}"/>
                  </a:ext>
                </a:extLst>
              </p:cNvPr>
              <p:cNvSpPr txBox="1"/>
              <p:nvPr/>
            </p:nvSpPr>
            <p:spPr>
              <a:xfrm>
                <a:off x="9356522" y="3505289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27</a:t>
                </a:r>
                <a:endParaRPr lang="en-US" dirty="0"/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89B382A3-0DC2-40C1-BA74-F8C5D38537DE}"/>
                </a:ext>
              </a:extLst>
            </p:cNvPr>
            <p:cNvGrpSpPr/>
            <p:nvPr/>
          </p:nvGrpSpPr>
          <p:grpSpPr>
            <a:xfrm>
              <a:off x="8894682" y="578993"/>
              <a:ext cx="2772000" cy="2469354"/>
              <a:chOff x="8894682" y="578993"/>
              <a:chExt cx="2772000" cy="2469354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E8772FE8-C043-46FC-A528-E19E5EC9A9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t="3988" r="2620"/>
              <a:stretch/>
            </p:blipFill>
            <p:spPr>
              <a:xfrm>
                <a:off x="8894682" y="908901"/>
                <a:ext cx="2772000" cy="2139446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5329577-72D0-432C-9BF3-45C7FD1CB347}"/>
                  </a:ext>
                </a:extLst>
              </p:cNvPr>
              <p:cNvSpPr txBox="1"/>
              <p:nvPr/>
            </p:nvSpPr>
            <p:spPr>
              <a:xfrm>
                <a:off x="9772497" y="578993"/>
                <a:ext cx="112697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dirty="0"/>
                  <a:t>Cluster 14</a:t>
                </a:r>
                <a:endParaRPr 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91137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3</TotalTime>
  <Words>287</Words>
  <Application>Microsoft Office PowerPoint</Application>
  <PresentationFormat>Widescreen</PresentationFormat>
  <Paragraphs>88</Paragraphs>
  <Slides>1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T</dc:creator>
  <cp:lastModifiedBy>IT</cp:lastModifiedBy>
  <cp:revision>329</cp:revision>
  <dcterms:created xsi:type="dcterms:W3CDTF">2024-12-20T05:14:59Z</dcterms:created>
  <dcterms:modified xsi:type="dcterms:W3CDTF">2025-05-07T04:52:15Z</dcterms:modified>
</cp:coreProperties>
</file>